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95713-8088-4AFB-A978-555EA60D0D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2F8DA-542F-4E38-AFF1-31C1FF83A5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A3AB3-3255-44F6-9073-F14660F826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EE615-DE7D-4626-AC80-5E378A7161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AD558-144D-41E7-8185-98B629CF78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ECE5A-535A-41AD-9774-BEC10F3ED6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3E8029-4BE1-45C1-9421-57C8582375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D50C2-EEAB-41C5-9A44-C1806EA670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50506-24EE-4714-B3EF-2F9A58B2BF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B4C9CE-27A0-41BC-BED9-8D4C7AFCCE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78CE8-B7AD-448D-8FA4-449541B5D7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023B7-0224-4874-90CD-6281AB8DF8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2C6FD5-96D1-4921-8204-88447C544E0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97080" y="558720"/>
            <a:ext cx="99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 Rounded MT Bold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85640" y="1260360"/>
            <a:ext cx="6034320" cy="4428720"/>
            <a:chOff x="485640" y="1260360"/>
            <a:chExt cx="6034320" cy="4428720"/>
          </a:xfrm>
        </p:grpSpPr>
        <p:sp>
          <p:nvSpPr>
            <p:cNvPr id="43" name=""/>
            <p:cNvSpPr/>
            <p:nvPr/>
          </p:nvSpPr>
          <p:spPr>
            <a:xfrm>
              <a:off x="633240" y="3683160"/>
              <a:ext cx="2810160" cy="1874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949320" y="3825720"/>
              <a:ext cx="31680" cy="1424160"/>
            </a:xfrm>
            <a:custGeom>
              <a:avLst/>
              <a:gdLst/>
              <a:ahLst/>
              <a:rect l="l" t="t" r="r" b="b"/>
              <a:pathLst>
                <a:path w="20" h="897">
                  <a:moveTo>
                    <a:pt x="0" y="0"/>
                  </a:moveTo>
                  <a:lnTo>
                    <a:pt x="0" y="897"/>
                  </a:lnTo>
                  <a:lnTo>
                    <a:pt x="20" y="897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949320" y="4894200"/>
              <a:ext cx="3168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949320" y="4537080"/>
              <a:ext cx="316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949320" y="4181400"/>
              <a:ext cx="3168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949320" y="3825720"/>
              <a:ext cx="3168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949320" y="5249880"/>
              <a:ext cx="2324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94932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133668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172404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211140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249876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288612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3273480" y="521820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50760" y="3995640"/>
              <a:ext cx="4932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47880" y="399096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6"/>
                  </a:lnTo>
                  <a:lnTo>
                    <a:pt x="15" y="31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971640" y="4287960"/>
              <a:ext cx="4896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968400" y="4284720"/>
              <a:ext cx="4932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127160" y="4842000"/>
              <a:ext cx="4932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122480" y="483696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868480" y="5051520"/>
              <a:ext cx="4932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865600" y="504828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950760" y="3979800"/>
              <a:ext cx="4932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947880" y="397656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5"/>
                  </a:lnTo>
                  <a:lnTo>
                    <a:pt x="15" y="31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971640" y="427356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968400" y="4268880"/>
              <a:ext cx="4932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6"/>
                  </a:lnTo>
                  <a:lnTo>
                    <a:pt x="15" y="31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127160" y="4826160"/>
              <a:ext cx="4932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6"/>
                  </a:lnTo>
                  <a:lnTo>
                    <a:pt x="15" y="31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122480" y="4822920"/>
              <a:ext cx="4896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868480" y="5035680"/>
              <a:ext cx="49320" cy="4896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6"/>
                  </a:lnTo>
                  <a:lnTo>
                    <a:pt x="15" y="31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865600" y="5032440"/>
              <a:ext cx="4896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5" y="0"/>
                  </a:moveTo>
                  <a:lnTo>
                    <a:pt x="31" y="16"/>
                  </a:lnTo>
                  <a:lnTo>
                    <a:pt x="15" y="31"/>
                  </a:lnTo>
                  <a:lnTo>
                    <a:pt x="0" y="16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968400" y="4037040"/>
              <a:ext cx="1917720" cy="1028520"/>
            </a:xfrm>
            <a:custGeom>
              <a:avLst/>
              <a:gdLst/>
              <a:ahLst/>
              <a:rect l="l" t="t" r="r" b="b"/>
              <a:pathLst>
                <a:path w="1208" h="648">
                  <a:moveTo>
                    <a:pt x="0" y="0"/>
                  </a:moveTo>
                  <a:lnTo>
                    <a:pt x="5" y="86"/>
                  </a:lnTo>
                  <a:lnTo>
                    <a:pt x="8" y="145"/>
                  </a:lnTo>
                  <a:lnTo>
                    <a:pt x="13" y="189"/>
                  </a:lnTo>
                  <a:lnTo>
                    <a:pt x="17" y="225"/>
                  </a:lnTo>
                  <a:lnTo>
                    <a:pt x="20" y="253"/>
                  </a:lnTo>
                  <a:lnTo>
                    <a:pt x="25" y="277"/>
                  </a:lnTo>
                  <a:lnTo>
                    <a:pt x="28" y="299"/>
                  </a:lnTo>
                  <a:lnTo>
                    <a:pt x="33" y="316"/>
                  </a:lnTo>
                  <a:lnTo>
                    <a:pt x="37" y="332"/>
                  </a:lnTo>
                  <a:lnTo>
                    <a:pt x="42" y="346"/>
                  </a:lnTo>
                  <a:lnTo>
                    <a:pt x="45" y="358"/>
                  </a:lnTo>
                  <a:lnTo>
                    <a:pt x="49" y="370"/>
                  </a:lnTo>
                  <a:lnTo>
                    <a:pt x="53" y="379"/>
                  </a:lnTo>
                  <a:lnTo>
                    <a:pt x="57" y="389"/>
                  </a:lnTo>
                  <a:lnTo>
                    <a:pt x="62" y="399"/>
                  </a:lnTo>
                  <a:lnTo>
                    <a:pt x="65" y="406"/>
                  </a:lnTo>
                  <a:lnTo>
                    <a:pt x="70" y="414"/>
                  </a:lnTo>
                  <a:lnTo>
                    <a:pt x="74" y="421"/>
                  </a:lnTo>
                  <a:lnTo>
                    <a:pt x="77" y="427"/>
                  </a:lnTo>
                  <a:lnTo>
                    <a:pt x="82" y="433"/>
                  </a:lnTo>
                  <a:lnTo>
                    <a:pt x="86" y="439"/>
                  </a:lnTo>
                  <a:lnTo>
                    <a:pt x="90" y="444"/>
                  </a:lnTo>
                  <a:lnTo>
                    <a:pt x="94" y="450"/>
                  </a:lnTo>
                  <a:lnTo>
                    <a:pt x="99" y="454"/>
                  </a:lnTo>
                  <a:lnTo>
                    <a:pt x="102" y="459"/>
                  </a:lnTo>
                  <a:lnTo>
                    <a:pt x="106" y="463"/>
                  </a:lnTo>
                  <a:lnTo>
                    <a:pt x="111" y="468"/>
                  </a:lnTo>
                  <a:lnTo>
                    <a:pt x="114" y="471"/>
                  </a:lnTo>
                  <a:lnTo>
                    <a:pt x="119" y="475"/>
                  </a:lnTo>
                  <a:lnTo>
                    <a:pt x="122" y="478"/>
                  </a:lnTo>
                  <a:lnTo>
                    <a:pt x="127" y="482"/>
                  </a:lnTo>
                  <a:lnTo>
                    <a:pt x="131" y="485"/>
                  </a:lnTo>
                  <a:lnTo>
                    <a:pt x="134" y="489"/>
                  </a:lnTo>
                  <a:lnTo>
                    <a:pt x="139" y="491"/>
                  </a:lnTo>
                  <a:lnTo>
                    <a:pt x="143" y="495"/>
                  </a:lnTo>
                  <a:lnTo>
                    <a:pt x="147" y="497"/>
                  </a:lnTo>
                  <a:lnTo>
                    <a:pt x="151" y="501"/>
                  </a:lnTo>
                  <a:lnTo>
                    <a:pt x="156" y="503"/>
                  </a:lnTo>
                  <a:lnTo>
                    <a:pt x="159" y="506"/>
                  </a:lnTo>
                  <a:lnTo>
                    <a:pt x="163" y="508"/>
                  </a:lnTo>
                  <a:lnTo>
                    <a:pt x="168" y="510"/>
                  </a:lnTo>
                  <a:lnTo>
                    <a:pt x="171" y="513"/>
                  </a:lnTo>
                  <a:lnTo>
                    <a:pt x="176" y="515"/>
                  </a:lnTo>
                  <a:lnTo>
                    <a:pt x="180" y="518"/>
                  </a:lnTo>
                  <a:lnTo>
                    <a:pt x="184" y="520"/>
                  </a:lnTo>
                  <a:lnTo>
                    <a:pt x="188" y="521"/>
                  </a:lnTo>
                  <a:lnTo>
                    <a:pt x="191" y="524"/>
                  </a:lnTo>
                  <a:lnTo>
                    <a:pt x="196" y="526"/>
                  </a:lnTo>
                  <a:lnTo>
                    <a:pt x="200" y="527"/>
                  </a:lnTo>
                  <a:lnTo>
                    <a:pt x="205" y="529"/>
                  </a:lnTo>
                  <a:lnTo>
                    <a:pt x="208" y="531"/>
                  </a:lnTo>
                  <a:lnTo>
                    <a:pt x="213" y="533"/>
                  </a:lnTo>
                  <a:lnTo>
                    <a:pt x="216" y="534"/>
                  </a:lnTo>
                  <a:lnTo>
                    <a:pt x="220" y="537"/>
                  </a:lnTo>
                  <a:lnTo>
                    <a:pt x="225" y="538"/>
                  </a:lnTo>
                  <a:lnTo>
                    <a:pt x="228" y="539"/>
                  </a:lnTo>
                  <a:lnTo>
                    <a:pt x="233" y="541"/>
                  </a:lnTo>
                  <a:lnTo>
                    <a:pt x="237" y="543"/>
                  </a:lnTo>
                  <a:lnTo>
                    <a:pt x="241" y="544"/>
                  </a:lnTo>
                  <a:lnTo>
                    <a:pt x="245" y="545"/>
                  </a:lnTo>
                  <a:lnTo>
                    <a:pt x="249" y="546"/>
                  </a:lnTo>
                  <a:lnTo>
                    <a:pt x="253" y="549"/>
                  </a:lnTo>
                  <a:lnTo>
                    <a:pt x="257" y="550"/>
                  </a:lnTo>
                  <a:lnTo>
                    <a:pt x="262" y="551"/>
                  </a:lnTo>
                  <a:lnTo>
                    <a:pt x="265" y="552"/>
                  </a:lnTo>
                  <a:lnTo>
                    <a:pt x="270" y="553"/>
                  </a:lnTo>
                  <a:lnTo>
                    <a:pt x="274" y="554"/>
                  </a:lnTo>
                  <a:lnTo>
                    <a:pt x="277" y="556"/>
                  </a:lnTo>
                  <a:lnTo>
                    <a:pt x="282" y="557"/>
                  </a:lnTo>
                  <a:lnTo>
                    <a:pt x="285" y="558"/>
                  </a:lnTo>
                  <a:lnTo>
                    <a:pt x="290" y="559"/>
                  </a:lnTo>
                  <a:lnTo>
                    <a:pt x="294" y="560"/>
                  </a:lnTo>
                  <a:lnTo>
                    <a:pt x="299" y="562"/>
                  </a:lnTo>
                  <a:lnTo>
                    <a:pt x="302" y="563"/>
                  </a:lnTo>
                  <a:lnTo>
                    <a:pt x="306" y="564"/>
                  </a:lnTo>
                  <a:lnTo>
                    <a:pt x="310" y="565"/>
                  </a:lnTo>
                  <a:lnTo>
                    <a:pt x="314" y="565"/>
                  </a:lnTo>
                  <a:lnTo>
                    <a:pt x="319" y="566"/>
                  </a:lnTo>
                  <a:lnTo>
                    <a:pt x="322" y="568"/>
                  </a:lnTo>
                  <a:lnTo>
                    <a:pt x="327" y="569"/>
                  </a:lnTo>
                  <a:lnTo>
                    <a:pt x="331" y="570"/>
                  </a:lnTo>
                  <a:lnTo>
                    <a:pt x="334" y="571"/>
                  </a:lnTo>
                  <a:lnTo>
                    <a:pt x="339" y="571"/>
                  </a:lnTo>
                  <a:lnTo>
                    <a:pt x="343" y="572"/>
                  </a:lnTo>
                  <a:lnTo>
                    <a:pt x="347" y="574"/>
                  </a:lnTo>
                  <a:lnTo>
                    <a:pt x="351" y="575"/>
                  </a:lnTo>
                  <a:lnTo>
                    <a:pt x="356" y="575"/>
                  </a:lnTo>
                  <a:lnTo>
                    <a:pt x="359" y="576"/>
                  </a:lnTo>
                  <a:lnTo>
                    <a:pt x="363" y="577"/>
                  </a:lnTo>
                  <a:lnTo>
                    <a:pt x="368" y="577"/>
                  </a:lnTo>
                  <a:lnTo>
                    <a:pt x="371" y="578"/>
                  </a:lnTo>
                  <a:lnTo>
                    <a:pt x="376" y="579"/>
                  </a:lnTo>
                  <a:lnTo>
                    <a:pt x="379" y="579"/>
                  </a:lnTo>
                  <a:lnTo>
                    <a:pt x="384" y="581"/>
                  </a:lnTo>
                  <a:lnTo>
                    <a:pt x="388" y="582"/>
                  </a:lnTo>
                  <a:lnTo>
                    <a:pt x="391" y="582"/>
                  </a:lnTo>
                  <a:lnTo>
                    <a:pt x="396" y="583"/>
                  </a:lnTo>
                  <a:lnTo>
                    <a:pt x="400" y="584"/>
                  </a:lnTo>
                  <a:lnTo>
                    <a:pt x="404" y="584"/>
                  </a:lnTo>
                  <a:lnTo>
                    <a:pt x="408" y="585"/>
                  </a:lnTo>
                  <a:lnTo>
                    <a:pt x="412" y="585"/>
                  </a:lnTo>
                  <a:lnTo>
                    <a:pt x="416" y="587"/>
                  </a:lnTo>
                  <a:lnTo>
                    <a:pt x="420" y="588"/>
                  </a:lnTo>
                  <a:lnTo>
                    <a:pt x="425" y="588"/>
                  </a:lnTo>
                  <a:lnTo>
                    <a:pt x="428" y="589"/>
                  </a:lnTo>
                  <a:lnTo>
                    <a:pt x="433" y="589"/>
                  </a:lnTo>
                  <a:lnTo>
                    <a:pt x="437" y="590"/>
                  </a:lnTo>
                  <a:lnTo>
                    <a:pt x="440" y="590"/>
                  </a:lnTo>
                  <a:lnTo>
                    <a:pt x="445" y="591"/>
                  </a:lnTo>
                  <a:lnTo>
                    <a:pt x="448" y="591"/>
                  </a:lnTo>
                  <a:lnTo>
                    <a:pt x="453" y="593"/>
                  </a:lnTo>
                  <a:lnTo>
                    <a:pt x="457" y="593"/>
                  </a:lnTo>
                  <a:lnTo>
                    <a:pt x="462" y="594"/>
                  </a:lnTo>
                  <a:lnTo>
                    <a:pt x="465" y="594"/>
                  </a:lnTo>
                  <a:lnTo>
                    <a:pt x="469" y="595"/>
                  </a:lnTo>
                  <a:lnTo>
                    <a:pt x="473" y="595"/>
                  </a:lnTo>
                  <a:lnTo>
                    <a:pt x="477" y="596"/>
                  </a:lnTo>
                  <a:lnTo>
                    <a:pt x="482" y="596"/>
                  </a:lnTo>
                  <a:lnTo>
                    <a:pt x="485" y="597"/>
                  </a:lnTo>
                  <a:lnTo>
                    <a:pt x="490" y="597"/>
                  </a:lnTo>
                  <a:lnTo>
                    <a:pt x="494" y="599"/>
                  </a:lnTo>
                  <a:lnTo>
                    <a:pt x="497" y="599"/>
                  </a:lnTo>
                  <a:lnTo>
                    <a:pt x="502" y="600"/>
                  </a:lnTo>
                  <a:lnTo>
                    <a:pt x="506" y="600"/>
                  </a:lnTo>
                  <a:lnTo>
                    <a:pt x="510" y="601"/>
                  </a:lnTo>
                  <a:lnTo>
                    <a:pt x="514" y="601"/>
                  </a:lnTo>
                  <a:lnTo>
                    <a:pt x="519" y="602"/>
                  </a:lnTo>
                  <a:lnTo>
                    <a:pt x="522" y="602"/>
                  </a:lnTo>
                  <a:lnTo>
                    <a:pt x="526" y="602"/>
                  </a:lnTo>
                  <a:lnTo>
                    <a:pt x="531" y="603"/>
                  </a:lnTo>
                  <a:lnTo>
                    <a:pt x="534" y="603"/>
                  </a:lnTo>
                  <a:lnTo>
                    <a:pt x="539" y="604"/>
                  </a:lnTo>
                  <a:lnTo>
                    <a:pt x="543" y="604"/>
                  </a:lnTo>
                  <a:lnTo>
                    <a:pt x="547" y="604"/>
                  </a:lnTo>
                  <a:lnTo>
                    <a:pt x="551" y="606"/>
                  </a:lnTo>
                  <a:lnTo>
                    <a:pt x="554" y="606"/>
                  </a:lnTo>
                  <a:lnTo>
                    <a:pt x="559" y="607"/>
                  </a:lnTo>
                  <a:lnTo>
                    <a:pt x="563" y="607"/>
                  </a:lnTo>
                  <a:lnTo>
                    <a:pt x="567" y="607"/>
                  </a:lnTo>
                  <a:lnTo>
                    <a:pt x="571" y="608"/>
                  </a:lnTo>
                  <a:lnTo>
                    <a:pt x="576" y="608"/>
                  </a:lnTo>
                  <a:lnTo>
                    <a:pt x="579" y="609"/>
                  </a:lnTo>
                  <a:lnTo>
                    <a:pt x="583" y="609"/>
                  </a:lnTo>
                  <a:lnTo>
                    <a:pt x="588" y="609"/>
                  </a:lnTo>
                  <a:lnTo>
                    <a:pt x="591" y="610"/>
                  </a:lnTo>
                  <a:lnTo>
                    <a:pt x="596" y="610"/>
                  </a:lnTo>
                  <a:lnTo>
                    <a:pt x="600" y="610"/>
                  </a:lnTo>
                  <a:lnTo>
                    <a:pt x="604" y="612"/>
                  </a:lnTo>
                  <a:lnTo>
                    <a:pt x="608" y="612"/>
                  </a:lnTo>
                  <a:lnTo>
                    <a:pt x="612" y="612"/>
                  </a:lnTo>
                  <a:lnTo>
                    <a:pt x="616" y="613"/>
                  </a:lnTo>
                  <a:lnTo>
                    <a:pt x="620" y="613"/>
                  </a:lnTo>
                  <a:lnTo>
                    <a:pt x="625" y="613"/>
                  </a:lnTo>
                  <a:lnTo>
                    <a:pt x="628" y="614"/>
                  </a:lnTo>
                  <a:lnTo>
                    <a:pt x="633" y="614"/>
                  </a:lnTo>
                  <a:lnTo>
                    <a:pt x="637" y="614"/>
                  </a:lnTo>
                  <a:lnTo>
                    <a:pt x="640" y="615"/>
                  </a:lnTo>
                  <a:lnTo>
                    <a:pt x="645" y="615"/>
                  </a:lnTo>
                  <a:lnTo>
                    <a:pt x="648" y="615"/>
                  </a:lnTo>
                  <a:lnTo>
                    <a:pt x="653" y="616"/>
                  </a:lnTo>
                  <a:lnTo>
                    <a:pt x="657" y="616"/>
                  </a:lnTo>
                  <a:lnTo>
                    <a:pt x="662" y="616"/>
                  </a:lnTo>
                  <a:lnTo>
                    <a:pt x="665" y="618"/>
                  </a:lnTo>
                  <a:lnTo>
                    <a:pt x="669" y="618"/>
                  </a:lnTo>
                  <a:lnTo>
                    <a:pt x="673" y="618"/>
                  </a:lnTo>
                  <a:lnTo>
                    <a:pt x="677" y="618"/>
                  </a:lnTo>
                  <a:lnTo>
                    <a:pt x="682" y="619"/>
                  </a:lnTo>
                  <a:lnTo>
                    <a:pt x="685" y="619"/>
                  </a:lnTo>
                  <a:lnTo>
                    <a:pt x="690" y="619"/>
                  </a:lnTo>
                  <a:lnTo>
                    <a:pt x="694" y="620"/>
                  </a:lnTo>
                  <a:lnTo>
                    <a:pt x="697" y="620"/>
                  </a:lnTo>
                  <a:lnTo>
                    <a:pt x="702" y="620"/>
                  </a:lnTo>
                  <a:lnTo>
                    <a:pt x="706" y="620"/>
                  </a:lnTo>
                  <a:lnTo>
                    <a:pt x="710" y="621"/>
                  </a:lnTo>
                  <a:lnTo>
                    <a:pt x="714" y="621"/>
                  </a:lnTo>
                  <a:lnTo>
                    <a:pt x="719" y="621"/>
                  </a:lnTo>
                  <a:lnTo>
                    <a:pt x="722" y="622"/>
                  </a:lnTo>
                  <a:lnTo>
                    <a:pt x="726" y="622"/>
                  </a:lnTo>
                  <a:lnTo>
                    <a:pt x="731" y="622"/>
                  </a:lnTo>
                  <a:lnTo>
                    <a:pt x="734" y="622"/>
                  </a:lnTo>
                  <a:lnTo>
                    <a:pt x="739" y="623"/>
                  </a:lnTo>
                  <a:lnTo>
                    <a:pt x="742" y="623"/>
                  </a:lnTo>
                  <a:lnTo>
                    <a:pt x="747" y="623"/>
                  </a:lnTo>
                  <a:lnTo>
                    <a:pt x="751" y="623"/>
                  </a:lnTo>
                  <a:lnTo>
                    <a:pt x="754" y="625"/>
                  </a:lnTo>
                  <a:lnTo>
                    <a:pt x="759" y="625"/>
                  </a:lnTo>
                  <a:lnTo>
                    <a:pt x="763" y="625"/>
                  </a:lnTo>
                  <a:lnTo>
                    <a:pt x="767" y="625"/>
                  </a:lnTo>
                  <a:lnTo>
                    <a:pt x="771" y="626"/>
                  </a:lnTo>
                  <a:lnTo>
                    <a:pt x="776" y="626"/>
                  </a:lnTo>
                  <a:lnTo>
                    <a:pt x="779" y="626"/>
                  </a:lnTo>
                  <a:lnTo>
                    <a:pt x="783" y="626"/>
                  </a:lnTo>
                  <a:lnTo>
                    <a:pt x="788" y="627"/>
                  </a:lnTo>
                  <a:lnTo>
                    <a:pt x="791" y="627"/>
                  </a:lnTo>
                  <a:lnTo>
                    <a:pt x="796" y="627"/>
                  </a:lnTo>
                  <a:lnTo>
                    <a:pt x="800" y="627"/>
                  </a:lnTo>
                  <a:lnTo>
                    <a:pt x="804" y="628"/>
                  </a:lnTo>
                  <a:lnTo>
                    <a:pt x="808" y="628"/>
                  </a:lnTo>
                  <a:lnTo>
                    <a:pt x="811" y="628"/>
                  </a:lnTo>
                  <a:lnTo>
                    <a:pt x="816" y="628"/>
                  </a:lnTo>
                  <a:lnTo>
                    <a:pt x="820" y="629"/>
                  </a:lnTo>
                  <a:lnTo>
                    <a:pt x="825" y="629"/>
                  </a:lnTo>
                  <a:lnTo>
                    <a:pt x="828" y="629"/>
                  </a:lnTo>
                  <a:lnTo>
                    <a:pt x="833" y="629"/>
                  </a:lnTo>
                  <a:lnTo>
                    <a:pt x="836" y="629"/>
                  </a:lnTo>
                  <a:lnTo>
                    <a:pt x="840" y="631"/>
                  </a:lnTo>
                  <a:lnTo>
                    <a:pt x="845" y="631"/>
                  </a:lnTo>
                  <a:lnTo>
                    <a:pt x="848" y="631"/>
                  </a:lnTo>
                  <a:lnTo>
                    <a:pt x="853" y="631"/>
                  </a:lnTo>
                  <a:lnTo>
                    <a:pt x="857" y="632"/>
                  </a:lnTo>
                  <a:lnTo>
                    <a:pt x="861" y="632"/>
                  </a:lnTo>
                  <a:lnTo>
                    <a:pt x="865" y="632"/>
                  </a:lnTo>
                  <a:lnTo>
                    <a:pt x="869" y="632"/>
                  </a:lnTo>
                  <a:lnTo>
                    <a:pt x="873" y="632"/>
                  </a:lnTo>
                  <a:lnTo>
                    <a:pt x="877" y="633"/>
                  </a:lnTo>
                  <a:lnTo>
                    <a:pt x="882" y="633"/>
                  </a:lnTo>
                  <a:lnTo>
                    <a:pt x="885" y="633"/>
                  </a:lnTo>
                  <a:lnTo>
                    <a:pt x="890" y="633"/>
                  </a:lnTo>
                  <a:lnTo>
                    <a:pt x="894" y="633"/>
                  </a:lnTo>
                  <a:lnTo>
                    <a:pt x="897" y="634"/>
                  </a:lnTo>
                  <a:lnTo>
                    <a:pt x="902" y="634"/>
                  </a:lnTo>
                  <a:lnTo>
                    <a:pt x="905" y="634"/>
                  </a:lnTo>
                  <a:lnTo>
                    <a:pt x="910" y="634"/>
                  </a:lnTo>
                  <a:lnTo>
                    <a:pt x="914" y="634"/>
                  </a:lnTo>
                  <a:lnTo>
                    <a:pt x="919" y="635"/>
                  </a:lnTo>
                  <a:lnTo>
                    <a:pt x="922" y="635"/>
                  </a:lnTo>
                  <a:lnTo>
                    <a:pt x="926" y="635"/>
                  </a:lnTo>
                  <a:lnTo>
                    <a:pt x="930" y="635"/>
                  </a:lnTo>
                  <a:lnTo>
                    <a:pt x="934" y="635"/>
                  </a:lnTo>
                  <a:lnTo>
                    <a:pt x="939" y="637"/>
                  </a:lnTo>
                  <a:lnTo>
                    <a:pt x="942" y="637"/>
                  </a:lnTo>
                  <a:lnTo>
                    <a:pt x="947" y="637"/>
                  </a:lnTo>
                  <a:lnTo>
                    <a:pt x="951" y="637"/>
                  </a:lnTo>
                  <a:lnTo>
                    <a:pt x="954" y="637"/>
                  </a:lnTo>
                  <a:lnTo>
                    <a:pt x="959" y="638"/>
                  </a:lnTo>
                  <a:lnTo>
                    <a:pt x="963" y="638"/>
                  </a:lnTo>
                  <a:lnTo>
                    <a:pt x="967" y="638"/>
                  </a:lnTo>
                  <a:lnTo>
                    <a:pt x="971" y="638"/>
                  </a:lnTo>
                  <a:lnTo>
                    <a:pt x="976" y="638"/>
                  </a:lnTo>
                  <a:lnTo>
                    <a:pt x="979" y="638"/>
                  </a:lnTo>
                  <a:lnTo>
                    <a:pt x="983" y="639"/>
                  </a:lnTo>
                  <a:lnTo>
                    <a:pt x="988" y="639"/>
                  </a:lnTo>
                  <a:lnTo>
                    <a:pt x="991" y="639"/>
                  </a:lnTo>
                  <a:lnTo>
                    <a:pt x="996" y="639"/>
                  </a:lnTo>
                  <a:lnTo>
                    <a:pt x="999" y="639"/>
                  </a:lnTo>
                  <a:lnTo>
                    <a:pt x="1004" y="639"/>
                  </a:lnTo>
                  <a:lnTo>
                    <a:pt x="1008" y="640"/>
                  </a:lnTo>
                  <a:lnTo>
                    <a:pt x="1011" y="640"/>
                  </a:lnTo>
                  <a:lnTo>
                    <a:pt x="1016" y="640"/>
                  </a:lnTo>
                  <a:lnTo>
                    <a:pt x="1020" y="640"/>
                  </a:lnTo>
                  <a:lnTo>
                    <a:pt x="1024" y="640"/>
                  </a:lnTo>
                  <a:lnTo>
                    <a:pt x="1028" y="640"/>
                  </a:lnTo>
                  <a:lnTo>
                    <a:pt x="1033" y="641"/>
                  </a:lnTo>
                  <a:lnTo>
                    <a:pt x="1036" y="641"/>
                  </a:lnTo>
                  <a:lnTo>
                    <a:pt x="1040" y="641"/>
                  </a:lnTo>
                  <a:lnTo>
                    <a:pt x="1045" y="641"/>
                  </a:lnTo>
                  <a:lnTo>
                    <a:pt x="1048" y="641"/>
                  </a:lnTo>
                  <a:lnTo>
                    <a:pt x="1053" y="641"/>
                  </a:lnTo>
                  <a:lnTo>
                    <a:pt x="1057" y="643"/>
                  </a:lnTo>
                  <a:lnTo>
                    <a:pt x="1061" y="643"/>
                  </a:lnTo>
                  <a:lnTo>
                    <a:pt x="1065" y="643"/>
                  </a:lnTo>
                  <a:lnTo>
                    <a:pt x="1068" y="643"/>
                  </a:lnTo>
                  <a:lnTo>
                    <a:pt x="1073" y="643"/>
                  </a:lnTo>
                  <a:lnTo>
                    <a:pt x="1077" y="643"/>
                  </a:lnTo>
                  <a:lnTo>
                    <a:pt x="1082" y="644"/>
                  </a:lnTo>
                  <a:lnTo>
                    <a:pt x="1085" y="644"/>
                  </a:lnTo>
                  <a:lnTo>
                    <a:pt x="1090" y="644"/>
                  </a:lnTo>
                  <a:lnTo>
                    <a:pt x="1093" y="644"/>
                  </a:lnTo>
                  <a:lnTo>
                    <a:pt x="1097" y="644"/>
                  </a:lnTo>
                  <a:lnTo>
                    <a:pt x="1102" y="644"/>
                  </a:lnTo>
                  <a:lnTo>
                    <a:pt x="1105" y="645"/>
                  </a:lnTo>
                  <a:lnTo>
                    <a:pt x="1110" y="645"/>
                  </a:lnTo>
                  <a:lnTo>
                    <a:pt x="1114" y="645"/>
                  </a:lnTo>
                  <a:lnTo>
                    <a:pt x="1118" y="645"/>
                  </a:lnTo>
                  <a:lnTo>
                    <a:pt x="1122" y="645"/>
                  </a:lnTo>
                  <a:lnTo>
                    <a:pt x="1126" y="645"/>
                  </a:lnTo>
                  <a:lnTo>
                    <a:pt x="1130" y="645"/>
                  </a:lnTo>
                  <a:lnTo>
                    <a:pt x="1134" y="646"/>
                  </a:lnTo>
                  <a:lnTo>
                    <a:pt x="1139" y="646"/>
                  </a:lnTo>
                  <a:lnTo>
                    <a:pt x="1142" y="646"/>
                  </a:lnTo>
                  <a:lnTo>
                    <a:pt x="1147" y="646"/>
                  </a:lnTo>
                  <a:lnTo>
                    <a:pt x="1151" y="646"/>
                  </a:lnTo>
                  <a:lnTo>
                    <a:pt x="1154" y="646"/>
                  </a:lnTo>
                  <a:lnTo>
                    <a:pt x="1159" y="646"/>
                  </a:lnTo>
                  <a:lnTo>
                    <a:pt x="1162" y="647"/>
                  </a:lnTo>
                  <a:lnTo>
                    <a:pt x="1167" y="647"/>
                  </a:lnTo>
                  <a:lnTo>
                    <a:pt x="1171" y="647"/>
                  </a:lnTo>
                  <a:lnTo>
                    <a:pt x="1176" y="647"/>
                  </a:lnTo>
                  <a:lnTo>
                    <a:pt x="1179" y="647"/>
                  </a:lnTo>
                  <a:lnTo>
                    <a:pt x="1183" y="647"/>
                  </a:lnTo>
                  <a:lnTo>
                    <a:pt x="1187" y="647"/>
                  </a:lnTo>
                  <a:lnTo>
                    <a:pt x="1191" y="648"/>
                  </a:lnTo>
                  <a:lnTo>
                    <a:pt x="1196" y="648"/>
                  </a:lnTo>
                  <a:lnTo>
                    <a:pt x="1199" y="648"/>
                  </a:lnTo>
                  <a:lnTo>
                    <a:pt x="1204" y="648"/>
                  </a:lnTo>
                  <a:lnTo>
                    <a:pt x="1208" y="648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346480" y="4267080"/>
              <a:ext cx="4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451600" y="4307040"/>
              <a:ext cx="4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480760" y="4267080"/>
              <a:ext cx="45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= 0.98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14320" y="51865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757080" y="483084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00200" y="44737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00200" y="41194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700200" y="37623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906480" y="5345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265040" y="5345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652400" y="5345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039760" y="5345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427120" y="53452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786040" y="53452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173400" y="534528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85640" y="358452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U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758960" y="3551400"/>
              <a:ext cx="858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ERK1/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661040" y="5457960"/>
              <a:ext cx="913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fold dilution)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57280" y="1287360"/>
              <a:ext cx="3098880" cy="1967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966960" y="1523880"/>
              <a:ext cx="36360" cy="1479600"/>
            </a:xfrm>
            <a:custGeom>
              <a:avLst/>
              <a:gdLst/>
              <a:ahLst/>
              <a:rect l="l" t="t" r="r" b="b"/>
              <a:pathLst>
                <a:path w="23" h="932">
                  <a:moveTo>
                    <a:pt x="0" y="0"/>
                  </a:moveTo>
                  <a:lnTo>
                    <a:pt x="0" y="932"/>
                  </a:lnTo>
                  <a:lnTo>
                    <a:pt x="23" y="932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966960" y="2706840"/>
              <a:ext cx="36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966960" y="2411280"/>
              <a:ext cx="36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966960" y="2114640"/>
              <a:ext cx="36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966960" y="1820880"/>
              <a:ext cx="36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966960" y="1523880"/>
              <a:ext cx="36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966960" y="3003480"/>
              <a:ext cx="23558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96696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135900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175104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214488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253692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292896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3322800" y="2970360"/>
              <a:ext cx="1440" cy="33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968400" y="1846440"/>
              <a:ext cx="50760" cy="4896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965160" y="1841400"/>
              <a:ext cx="49320" cy="50760"/>
            </a:xfrm>
            <a:custGeom>
              <a:avLst/>
              <a:gdLst/>
              <a:ahLst/>
              <a:rect l="l" t="t" r="r" b="b"/>
              <a:pathLst>
                <a:path w="31" h="32">
                  <a:moveTo>
                    <a:pt x="16" y="0"/>
                  </a:moveTo>
                  <a:lnTo>
                    <a:pt x="31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987480" y="208764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984240" y="208440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146240" y="274320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143000" y="2739960"/>
              <a:ext cx="4932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911320" y="2962440"/>
              <a:ext cx="5112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908440" y="2959200"/>
              <a:ext cx="50760" cy="4896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968400" y="1830240"/>
              <a:ext cx="50760" cy="4932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965160" y="1825560"/>
              <a:ext cx="49320" cy="50760"/>
            </a:xfrm>
            <a:custGeom>
              <a:avLst/>
              <a:gdLst/>
              <a:ahLst/>
              <a:rect l="l" t="t" r="r" b="b"/>
              <a:pathLst>
                <a:path w="31" h="32">
                  <a:moveTo>
                    <a:pt x="16" y="0"/>
                  </a:moveTo>
                  <a:lnTo>
                    <a:pt x="31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987480" y="2073240"/>
              <a:ext cx="50760" cy="4932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984240" y="206856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146240" y="272736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143000" y="2724120"/>
              <a:ext cx="49320" cy="49320"/>
            </a:xfrm>
            <a:custGeom>
              <a:avLst/>
              <a:gdLst/>
              <a:ahLst/>
              <a:rect l="l" t="t" r="r" b="b"/>
              <a:pathLst>
                <a:path w="31" h="31">
                  <a:moveTo>
                    <a:pt x="16" y="0"/>
                  </a:moveTo>
                  <a:lnTo>
                    <a:pt x="31" y="16"/>
                  </a:lnTo>
                  <a:lnTo>
                    <a:pt x="16" y="31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911320" y="2948040"/>
              <a:ext cx="51120" cy="4932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15"/>
                  </a:lnTo>
                  <a:lnTo>
                    <a:pt x="16" y="31"/>
                  </a:lnTo>
                  <a:lnTo>
                    <a:pt x="0" y="15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908440" y="294336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985680" y="1652760"/>
              <a:ext cx="1943280" cy="1309680"/>
            </a:xfrm>
            <a:custGeom>
              <a:avLst/>
              <a:gdLst/>
              <a:ahLst/>
              <a:rect l="l" t="t" r="r" b="b"/>
              <a:pathLst>
                <a:path w="1224" h="825">
                  <a:moveTo>
                    <a:pt x="0" y="0"/>
                  </a:moveTo>
                  <a:lnTo>
                    <a:pt x="4" y="158"/>
                  </a:lnTo>
                  <a:lnTo>
                    <a:pt x="7" y="260"/>
                  </a:lnTo>
                  <a:lnTo>
                    <a:pt x="12" y="334"/>
                  </a:lnTo>
                  <a:lnTo>
                    <a:pt x="16" y="389"/>
                  </a:lnTo>
                  <a:lnTo>
                    <a:pt x="20" y="432"/>
                  </a:lnTo>
                  <a:lnTo>
                    <a:pt x="23" y="467"/>
                  </a:lnTo>
                  <a:lnTo>
                    <a:pt x="27" y="495"/>
                  </a:lnTo>
                  <a:lnTo>
                    <a:pt x="31" y="520"/>
                  </a:lnTo>
                  <a:lnTo>
                    <a:pt x="35" y="540"/>
                  </a:lnTo>
                  <a:lnTo>
                    <a:pt x="39" y="558"/>
                  </a:lnTo>
                  <a:lnTo>
                    <a:pt x="43" y="574"/>
                  </a:lnTo>
                  <a:lnTo>
                    <a:pt x="46" y="589"/>
                  </a:lnTo>
                  <a:lnTo>
                    <a:pt x="50" y="601"/>
                  </a:lnTo>
                  <a:lnTo>
                    <a:pt x="54" y="612"/>
                  </a:lnTo>
                  <a:lnTo>
                    <a:pt x="57" y="621"/>
                  </a:lnTo>
                  <a:lnTo>
                    <a:pt x="62" y="631"/>
                  </a:lnTo>
                  <a:lnTo>
                    <a:pt x="66" y="638"/>
                  </a:lnTo>
                  <a:lnTo>
                    <a:pt x="70" y="647"/>
                  </a:lnTo>
                  <a:lnTo>
                    <a:pt x="73" y="653"/>
                  </a:lnTo>
                  <a:lnTo>
                    <a:pt x="77" y="660"/>
                  </a:lnTo>
                  <a:lnTo>
                    <a:pt x="81" y="666"/>
                  </a:lnTo>
                  <a:lnTo>
                    <a:pt x="84" y="671"/>
                  </a:lnTo>
                  <a:lnTo>
                    <a:pt x="89" y="677"/>
                  </a:lnTo>
                  <a:lnTo>
                    <a:pt x="93" y="682"/>
                  </a:lnTo>
                  <a:lnTo>
                    <a:pt x="96" y="686"/>
                  </a:lnTo>
                  <a:lnTo>
                    <a:pt x="100" y="691"/>
                  </a:lnTo>
                  <a:lnTo>
                    <a:pt x="104" y="694"/>
                  </a:lnTo>
                  <a:lnTo>
                    <a:pt x="107" y="698"/>
                  </a:lnTo>
                  <a:lnTo>
                    <a:pt x="112" y="702"/>
                  </a:lnTo>
                  <a:lnTo>
                    <a:pt x="116" y="705"/>
                  </a:lnTo>
                  <a:lnTo>
                    <a:pt x="119" y="709"/>
                  </a:lnTo>
                  <a:lnTo>
                    <a:pt x="123" y="711"/>
                  </a:lnTo>
                  <a:lnTo>
                    <a:pt x="127" y="715"/>
                  </a:lnTo>
                  <a:lnTo>
                    <a:pt x="130" y="717"/>
                  </a:lnTo>
                  <a:lnTo>
                    <a:pt x="134" y="720"/>
                  </a:lnTo>
                  <a:lnTo>
                    <a:pt x="139" y="722"/>
                  </a:lnTo>
                  <a:lnTo>
                    <a:pt x="143" y="725"/>
                  </a:lnTo>
                  <a:lnTo>
                    <a:pt x="146" y="727"/>
                  </a:lnTo>
                  <a:lnTo>
                    <a:pt x="150" y="729"/>
                  </a:lnTo>
                  <a:lnTo>
                    <a:pt x="154" y="732"/>
                  </a:lnTo>
                  <a:lnTo>
                    <a:pt x="157" y="733"/>
                  </a:lnTo>
                  <a:lnTo>
                    <a:pt x="161" y="736"/>
                  </a:lnTo>
                  <a:lnTo>
                    <a:pt x="166" y="738"/>
                  </a:lnTo>
                  <a:lnTo>
                    <a:pt x="169" y="739"/>
                  </a:lnTo>
                  <a:lnTo>
                    <a:pt x="173" y="742"/>
                  </a:lnTo>
                  <a:lnTo>
                    <a:pt x="177" y="743"/>
                  </a:lnTo>
                  <a:lnTo>
                    <a:pt x="180" y="744"/>
                  </a:lnTo>
                  <a:lnTo>
                    <a:pt x="184" y="746"/>
                  </a:lnTo>
                  <a:lnTo>
                    <a:pt x="189" y="748"/>
                  </a:lnTo>
                  <a:lnTo>
                    <a:pt x="193" y="749"/>
                  </a:lnTo>
                  <a:lnTo>
                    <a:pt x="196" y="750"/>
                  </a:lnTo>
                  <a:lnTo>
                    <a:pt x="200" y="751"/>
                  </a:lnTo>
                  <a:lnTo>
                    <a:pt x="204" y="754"/>
                  </a:lnTo>
                  <a:lnTo>
                    <a:pt x="207" y="755"/>
                  </a:lnTo>
                  <a:lnTo>
                    <a:pt x="211" y="756"/>
                  </a:lnTo>
                  <a:lnTo>
                    <a:pt x="216" y="757"/>
                  </a:lnTo>
                  <a:lnTo>
                    <a:pt x="219" y="759"/>
                  </a:lnTo>
                  <a:lnTo>
                    <a:pt x="223" y="760"/>
                  </a:lnTo>
                  <a:lnTo>
                    <a:pt x="227" y="760"/>
                  </a:lnTo>
                  <a:lnTo>
                    <a:pt x="230" y="761"/>
                  </a:lnTo>
                  <a:lnTo>
                    <a:pt x="234" y="762"/>
                  </a:lnTo>
                  <a:lnTo>
                    <a:pt x="238" y="763"/>
                  </a:lnTo>
                  <a:lnTo>
                    <a:pt x="243" y="765"/>
                  </a:lnTo>
                  <a:lnTo>
                    <a:pt x="246" y="766"/>
                  </a:lnTo>
                  <a:lnTo>
                    <a:pt x="250" y="766"/>
                  </a:lnTo>
                  <a:lnTo>
                    <a:pt x="253" y="767"/>
                  </a:lnTo>
                  <a:lnTo>
                    <a:pt x="257" y="768"/>
                  </a:lnTo>
                  <a:lnTo>
                    <a:pt x="261" y="770"/>
                  </a:lnTo>
                  <a:lnTo>
                    <a:pt x="266" y="770"/>
                  </a:lnTo>
                  <a:lnTo>
                    <a:pt x="269" y="771"/>
                  </a:lnTo>
                  <a:lnTo>
                    <a:pt x="273" y="772"/>
                  </a:lnTo>
                  <a:lnTo>
                    <a:pt x="277" y="772"/>
                  </a:lnTo>
                  <a:lnTo>
                    <a:pt x="280" y="773"/>
                  </a:lnTo>
                  <a:lnTo>
                    <a:pt x="284" y="774"/>
                  </a:lnTo>
                  <a:lnTo>
                    <a:pt x="288" y="774"/>
                  </a:lnTo>
                  <a:lnTo>
                    <a:pt x="292" y="776"/>
                  </a:lnTo>
                  <a:lnTo>
                    <a:pt x="296" y="776"/>
                  </a:lnTo>
                  <a:lnTo>
                    <a:pt x="300" y="777"/>
                  </a:lnTo>
                  <a:lnTo>
                    <a:pt x="303" y="778"/>
                  </a:lnTo>
                  <a:lnTo>
                    <a:pt x="307" y="778"/>
                  </a:lnTo>
                  <a:lnTo>
                    <a:pt x="311" y="779"/>
                  </a:lnTo>
                  <a:lnTo>
                    <a:pt x="314" y="779"/>
                  </a:lnTo>
                  <a:lnTo>
                    <a:pt x="319" y="780"/>
                  </a:lnTo>
                  <a:lnTo>
                    <a:pt x="323" y="780"/>
                  </a:lnTo>
                  <a:lnTo>
                    <a:pt x="327" y="782"/>
                  </a:lnTo>
                  <a:lnTo>
                    <a:pt x="330" y="782"/>
                  </a:lnTo>
                  <a:lnTo>
                    <a:pt x="334" y="783"/>
                  </a:lnTo>
                  <a:lnTo>
                    <a:pt x="338" y="783"/>
                  </a:lnTo>
                  <a:lnTo>
                    <a:pt x="342" y="784"/>
                  </a:lnTo>
                  <a:lnTo>
                    <a:pt x="346" y="784"/>
                  </a:lnTo>
                  <a:lnTo>
                    <a:pt x="350" y="785"/>
                  </a:lnTo>
                  <a:lnTo>
                    <a:pt x="353" y="785"/>
                  </a:lnTo>
                  <a:lnTo>
                    <a:pt x="357" y="785"/>
                  </a:lnTo>
                  <a:lnTo>
                    <a:pt x="361" y="787"/>
                  </a:lnTo>
                  <a:lnTo>
                    <a:pt x="364" y="787"/>
                  </a:lnTo>
                  <a:lnTo>
                    <a:pt x="369" y="788"/>
                  </a:lnTo>
                  <a:lnTo>
                    <a:pt x="373" y="788"/>
                  </a:lnTo>
                  <a:lnTo>
                    <a:pt x="377" y="788"/>
                  </a:lnTo>
                  <a:lnTo>
                    <a:pt x="380" y="789"/>
                  </a:lnTo>
                  <a:lnTo>
                    <a:pt x="384" y="789"/>
                  </a:lnTo>
                  <a:lnTo>
                    <a:pt x="387" y="790"/>
                  </a:lnTo>
                  <a:lnTo>
                    <a:pt x="391" y="790"/>
                  </a:lnTo>
                  <a:lnTo>
                    <a:pt x="396" y="790"/>
                  </a:lnTo>
                  <a:lnTo>
                    <a:pt x="400" y="791"/>
                  </a:lnTo>
                  <a:lnTo>
                    <a:pt x="403" y="791"/>
                  </a:lnTo>
                  <a:lnTo>
                    <a:pt x="407" y="791"/>
                  </a:lnTo>
                  <a:lnTo>
                    <a:pt x="411" y="793"/>
                  </a:lnTo>
                  <a:lnTo>
                    <a:pt x="414" y="793"/>
                  </a:lnTo>
                  <a:lnTo>
                    <a:pt x="419" y="793"/>
                  </a:lnTo>
                  <a:lnTo>
                    <a:pt x="423" y="794"/>
                  </a:lnTo>
                  <a:lnTo>
                    <a:pt x="426" y="794"/>
                  </a:lnTo>
                  <a:lnTo>
                    <a:pt x="430" y="794"/>
                  </a:lnTo>
                  <a:lnTo>
                    <a:pt x="434" y="795"/>
                  </a:lnTo>
                  <a:lnTo>
                    <a:pt x="437" y="795"/>
                  </a:lnTo>
                  <a:lnTo>
                    <a:pt x="441" y="795"/>
                  </a:lnTo>
                  <a:lnTo>
                    <a:pt x="446" y="795"/>
                  </a:lnTo>
                  <a:lnTo>
                    <a:pt x="450" y="796"/>
                  </a:lnTo>
                  <a:lnTo>
                    <a:pt x="453" y="796"/>
                  </a:lnTo>
                  <a:lnTo>
                    <a:pt x="457" y="796"/>
                  </a:lnTo>
                  <a:lnTo>
                    <a:pt x="461" y="797"/>
                  </a:lnTo>
                  <a:lnTo>
                    <a:pt x="464" y="797"/>
                  </a:lnTo>
                  <a:lnTo>
                    <a:pt x="468" y="797"/>
                  </a:lnTo>
                  <a:lnTo>
                    <a:pt x="473" y="797"/>
                  </a:lnTo>
                  <a:lnTo>
                    <a:pt x="476" y="799"/>
                  </a:lnTo>
                  <a:lnTo>
                    <a:pt x="480" y="799"/>
                  </a:lnTo>
                  <a:lnTo>
                    <a:pt x="484" y="799"/>
                  </a:lnTo>
                  <a:lnTo>
                    <a:pt x="487" y="799"/>
                  </a:lnTo>
                  <a:lnTo>
                    <a:pt x="491" y="800"/>
                  </a:lnTo>
                  <a:lnTo>
                    <a:pt x="496" y="800"/>
                  </a:lnTo>
                  <a:lnTo>
                    <a:pt x="500" y="800"/>
                  </a:lnTo>
                  <a:lnTo>
                    <a:pt x="503" y="800"/>
                  </a:lnTo>
                  <a:lnTo>
                    <a:pt x="507" y="801"/>
                  </a:lnTo>
                  <a:lnTo>
                    <a:pt x="510" y="801"/>
                  </a:lnTo>
                  <a:lnTo>
                    <a:pt x="514" y="801"/>
                  </a:lnTo>
                  <a:lnTo>
                    <a:pt x="518" y="801"/>
                  </a:lnTo>
                  <a:lnTo>
                    <a:pt x="523" y="801"/>
                  </a:lnTo>
                  <a:lnTo>
                    <a:pt x="526" y="802"/>
                  </a:lnTo>
                  <a:lnTo>
                    <a:pt x="530" y="802"/>
                  </a:lnTo>
                  <a:lnTo>
                    <a:pt x="534" y="802"/>
                  </a:lnTo>
                  <a:lnTo>
                    <a:pt x="537" y="802"/>
                  </a:lnTo>
                  <a:lnTo>
                    <a:pt x="541" y="804"/>
                  </a:lnTo>
                  <a:lnTo>
                    <a:pt x="545" y="804"/>
                  </a:lnTo>
                  <a:lnTo>
                    <a:pt x="549" y="804"/>
                  </a:lnTo>
                  <a:lnTo>
                    <a:pt x="553" y="804"/>
                  </a:lnTo>
                  <a:lnTo>
                    <a:pt x="557" y="804"/>
                  </a:lnTo>
                  <a:lnTo>
                    <a:pt x="560" y="805"/>
                  </a:lnTo>
                  <a:lnTo>
                    <a:pt x="564" y="805"/>
                  </a:lnTo>
                  <a:lnTo>
                    <a:pt x="568" y="805"/>
                  </a:lnTo>
                  <a:lnTo>
                    <a:pt x="573" y="805"/>
                  </a:lnTo>
                  <a:lnTo>
                    <a:pt x="576" y="805"/>
                  </a:lnTo>
                  <a:lnTo>
                    <a:pt x="580" y="806"/>
                  </a:lnTo>
                  <a:lnTo>
                    <a:pt x="584" y="806"/>
                  </a:lnTo>
                  <a:lnTo>
                    <a:pt x="587" y="806"/>
                  </a:lnTo>
                  <a:lnTo>
                    <a:pt x="591" y="806"/>
                  </a:lnTo>
                  <a:lnTo>
                    <a:pt x="595" y="806"/>
                  </a:lnTo>
                  <a:lnTo>
                    <a:pt x="599" y="806"/>
                  </a:lnTo>
                  <a:lnTo>
                    <a:pt x="603" y="807"/>
                  </a:lnTo>
                  <a:lnTo>
                    <a:pt x="607" y="807"/>
                  </a:lnTo>
                  <a:lnTo>
                    <a:pt x="610" y="807"/>
                  </a:lnTo>
                  <a:lnTo>
                    <a:pt x="614" y="807"/>
                  </a:lnTo>
                  <a:lnTo>
                    <a:pt x="618" y="807"/>
                  </a:lnTo>
                  <a:lnTo>
                    <a:pt x="621" y="807"/>
                  </a:lnTo>
                  <a:lnTo>
                    <a:pt x="626" y="808"/>
                  </a:lnTo>
                  <a:lnTo>
                    <a:pt x="630" y="808"/>
                  </a:lnTo>
                  <a:lnTo>
                    <a:pt x="634" y="808"/>
                  </a:lnTo>
                  <a:lnTo>
                    <a:pt x="637" y="808"/>
                  </a:lnTo>
                  <a:lnTo>
                    <a:pt x="641" y="808"/>
                  </a:lnTo>
                  <a:lnTo>
                    <a:pt x="644" y="808"/>
                  </a:lnTo>
                  <a:lnTo>
                    <a:pt x="649" y="810"/>
                  </a:lnTo>
                  <a:lnTo>
                    <a:pt x="653" y="810"/>
                  </a:lnTo>
                  <a:lnTo>
                    <a:pt x="657" y="810"/>
                  </a:lnTo>
                  <a:lnTo>
                    <a:pt x="660" y="810"/>
                  </a:lnTo>
                  <a:lnTo>
                    <a:pt x="664" y="810"/>
                  </a:lnTo>
                  <a:lnTo>
                    <a:pt x="668" y="810"/>
                  </a:lnTo>
                  <a:lnTo>
                    <a:pt x="671" y="810"/>
                  </a:lnTo>
                  <a:lnTo>
                    <a:pt x="676" y="811"/>
                  </a:lnTo>
                  <a:lnTo>
                    <a:pt x="680" y="811"/>
                  </a:lnTo>
                  <a:lnTo>
                    <a:pt x="683" y="811"/>
                  </a:lnTo>
                  <a:lnTo>
                    <a:pt x="687" y="811"/>
                  </a:lnTo>
                  <a:lnTo>
                    <a:pt x="691" y="811"/>
                  </a:lnTo>
                  <a:lnTo>
                    <a:pt x="694" y="811"/>
                  </a:lnTo>
                  <a:lnTo>
                    <a:pt x="698" y="811"/>
                  </a:lnTo>
                  <a:lnTo>
                    <a:pt x="703" y="811"/>
                  </a:lnTo>
                  <a:lnTo>
                    <a:pt x="707" y="812"/>
                  </a:lnTo>
                  <a:lnTo>
                    <a:pt x="710" y="812"/>
                  </a:lnTo>
                  <a:lnTo>
                    <a:pt x="714" y="812"/>
                  </a:lnTo>
                  <a:lnTo>
                    <a:pt x="718" y="812"/>
                  </a:lnTo>
                  <a:lnTo>
                    <a:pt x="721" y="812"/>
                  </a:lnTo>
                  <a:lnTo>
                    <a:pt x="726" y="812"/>
                  </a:lnTo>
                  <a:lnTo>
                    <a:pt x="730" y="812"/>
                  </a:lnTo>
                  <a:lnTo>
                    <a:pt x="733" y="813"/>
                  </a:lnTo>
                  <a:lnTo>
                    <a:pt x="737" y="813"/>
                  </a:lnTo>
                  <a:lnTo>
                    <a:pt x="741" y="813"/>
                  </a:lnTo>
                  <a:lnTo>
                    <a:pt x="744" y="813"/>
                  </a:lnTo>
                  <a:lnTo>
                    <a:pt x="748" y="813"/>
                  </a:lnTo>
                  <a:lnTo>
                    <a:pt x="753" y="813"/>
                  </a:lnTo>
                  <a:lnTo>
                    <a:pt x="757" y="813"/>
                  </a:lnTo>
                  <a:lnTo>
                    <a:pt x="760" y="813"/>
                  </a:lnTo>
                  <a:lnTo>
                    <a:pt x="764" y="813"/>
                  </a:lnTo>
                  <a:lnTo>
                    <a:pt x="768" y="814"/>
                  </a:lnTo>
                  <a:lnTo>
                    <a:pt x="771" y="814"/>
                  </a:lnTo>
                  <a:lnTo>
                    <a:pt x="775" y="814"/>
                  </a:lnTo>
                  <a:lnTo>
                    <a:pt x="780" y="814"/>
                  </a:lnTo>
                  <a:lnTo>
                    <a:pt x="783" y="814"/>
                  </a:lnTo>
                  <a:lnTo>
                    <a:pt x="787" y="814"/>
                  </a:lnTo>
                  <a:lnTo>
                    <a:pt x="791" y="814"/>
                  </a:lnTo>
                  <a:lnTo>
                    <a:pt x="794" y="814"/>
                  </a:lnTo>
                  <a:lnTo>
                    <a:pt x="798" y="814"/>
                  </a:lnTo>
                  <a:lnTo>
                    <a:pt x="803" y="816"/>
                  </a:lnTo>
                  <a:lnTo>
                    <a:pt x="806" y="816"/>
                  </a:lnTo>
                  <a:lnTo>
                    <a:pt x="810" y="816"/>
                  </a:lnTo>
                  <a:lnTo>
                    <a:pt x="814" y="816"/>
                  </a:lnTo>
                  <a:lnTo>
                    <a:pt x="817" y="816"/>
                  </a:lnTo>
                  <a:lnTo>
                    <a:pt x="821" y="816"/>
                  </a:lnTo>
                  <a:lnTo>
                    <a:pt x="825" y="816"/>
                  </a:lnTo>
                  <a:lnTo>
                    <a:pt x="830" y="816"/>
                  </a:lnTo>
                  <a:lnTo>
                    <a:pt x="833" y="816"/>
                  </a:lnTo>
                  <a:lnTo>
                    <a:pt x="837" y="816"/>
                  </a:lnTo>
                  <a:lnTo>
                    <a:pt x="841" y="817"/>
                  </a:lnTo>
                  <a:lnTo>
                    <a:pt x="844" y="817"/>
                  </a:lnTo>
                  <a:lnTo>
                    <a:pt x="848" y="817"/>
                  </a:lnTo>
                  <a:lnTo>
                    <a:pt x="852" y="817"/>
                  </a:lnTo>
                  <a:lnTo>
                    <a:pt x="856" y="817"/>
                  </a:lnTo>
                  <a:lnTo>
                    <a:pt x="860" y="817"/>
                  </a:lnTo>
                  <a:lnTo>
                    <a:pt x="864" y="817"/>
                  </a:lnTo>
                  <a:lnTo>
                    <a:pt x="867" y="817"/>
                  </a:lnTo>
                  <a:lnTo>
                    <a:pt x="871" y="817"/>
                  </a:lnTo>
                  <a:lnTo>
                    <a:pt x="875" y="817"/>
                  </a:lnTo>
                  <a:lnTo>
                    <a:pt x="880" y="817"/>
                  </a:lnTo>
                  <a:lnTo>
                    <a:pt x="883" y="818"/>
                  </a:lnTo>
                  <a:lnTo>
                    <a:pt x="887" y="818"/>
                  </a:lnTo>
                  <a:lnTo>
                    <a:pt x="891" y="818"/>
                  </a:lnTo>
                  <a:lnTo>
                    <a:pt x="894" y="818"/>
                  </a:lnTo>
                  <a:lnTo>
                    <a:pt x="898" y="818"/>
                  </a:lnTo>
                  <a:lnTo>
                    <a:pt x="902" y="818"/>
                  </a:lnTo>
                  <a:lnTo>
                    <a:pt x="906" y="818"/>
                  </a:lnTo>
                  <a:lnTo>
                    <a:pt x="910" y="818"/>
                  </a:lnTo>
                  <a:lnTo>
                    <a:pt x="914" y="818"/>
                  </a:lnTo>
                  <a:lnTo>
                    <a:pt x="917" y="818"/>
                  </a:lnTo>
                  <a:lnTo>
                    <a:pt x="921" y="818"/>
                  </a:lnTo>
                  <a:lnTo>
                    <a:pt x="925" y="819"/>
                  </a:lnTo>
                  <a:lnTo>
                    <a:pt x="928" y="819"/>
                  </a:lnTo>
                  <a:lnTo>
                    <a:pt x="933" y="819"/>
                  </a:lnTo>
                  <a:lnTo>
                    <a:pt x="937" y="819"/>
                  </a:lnTo>
                  <a:lnTo>
                    <a:pt x="940" y="819"/>
                  </a:lnTo>
                  <a:lnTo>
                    <a:pt x="944" y="819"/>
                  </a:lnTo>
                  <a:lnTo>
                    <a:pt x="948" y="819"/>
                  </a:lnTo>
                  <a:lnTo>
                    <a:pt x="951" y="819"/>
                  </a:lnTo>
                  <a:lnTo>
                    <a:pt x="956" y="819"/>
                  </a:lnTo>
                  <a:lnTo>
                    <a:pt x="960" y="819"/>
                  </a:lnTo>
                  <a:lnTo>
                    <a:pt x="964" y="819"/>
                  </a:lnTo>
                  <a:lnTo>
                    <a:pt x="967" y="819"/>
                  </a:lnTo>
                  <a:lnTo>
                    <a:pt x="971" y="819"/>
                  </a:lnTo>
                  <a:lnTo>
                    <a:pt x="975" y="820"/>
                  </a:lnTo>
                  <a:lnTo>
                    <a:pt x="978" y="820"/>
                  </a:lnTo>
                  <a:lnTo>
                    <a:pt x="983" y="820"/>
                  </a:lnTo>
                  <a:lnTo>
                    <a:pt x="987" y="820"/>
                  </a:lnTo>
                  <a:lnTo>
                    <a:pt x="990" y="820"/>
                  </a:lnTo>
                  <a:lnTo>
                    <a:pt x="994" y="820"/>
                  </a:lnTo>
                  <a:lnTo>
                    <a:pt x="998" y="820"/>
                  </a:lnTo>
                  <a:lnTo>
                    <a:pt x="1001" y="820"/>
                  </a:lnTo>
                  <a:lnTo>
                    <a:pt x="1005" y="820"/>
                  </a:lnTo>
                  <a:lnTo>
                    <a:pt x="1010" y="820"/>
                  </a:lnTo>
                  <a:lnTo>
                    <a:pt x="1014" y="820"/>
                  </a:lnTo>
                  <a:lnTo>
                    <a:pt x="1017" y="820"/>
                  </a:lnTo>
                  <a:lnTo>
                    <a:pt x="1021" y="820"/>
                  </a:lnTo>
                  <a:lnTo>
                    <a:pt x="1025" y="820"/>
                  </a:lnTo>
                  <a:lnTo>
                    <a:pt x="1028" y="822"/>
                  </a:lnTo>
                  <a:lnTo>
                    <a:pt x="1033" y="822"/>
                  </a:lnTo>
                  <a:lnTo>
                    <a:pt x="1037" y="822"/>
                  </a:lnTo>
                  <a:lnTo>
                    <a:pt x="1040" y="822"/>
                  </a:lnTo>
                  <a:lnTo>
                    <a:pt x="1044" y="822"/>
                  </a:lnTo>
                  <a:lnTo>
                    <a:pt x="1048" y="822"/>
                  </a:lnTo>
                  <a:lnTo>
                    <a:pt x="1051" y="822"/>
                  </a:lnTo>
                  <a:lnTo>
                    <a:pt x="1055" y="822"/>
                  </a:lnTo>
                  <a:lnTo>
                    <a:pt x="1060" y="822"/>
                  </a:lnTo>
                  <a:lnTo>
                    <a:pt x="1064" y="822"/>
                  </a:lnTo>
                  <a:lnTo>
                    <a:pt x="1067" y="822"/>
                  </a:lnTo>
                  <a:lnTo>
                    <a:pt x="1071" y="822"/>
                  </a:lnTo>
                  <a:lnTo>
                    <a:pt x="1074" y="822"/>
                  </a:lnTo>
                  <a:lnTo>
                    <a:pt x="1078" y="822"/>
                  </a:lnTo>
                  <a:lnTo>
                    <a:pt x="1082" y="822"/>
                  </a:lnTo>
                  <a:lnTo>
                    <a:pt x="1087" y="823"/>
                  </a:lnTo>
                  <a:lnTo>
                    <a:pt x="1090" y="823"/>
                  </a:lnTo>
                  <a:lnTo>
                    <a:pt x="1094" y="823"/>
                  </a:lnTo>
                  <a:lnTo>
                    <a:pt x="1098" y="823"/>
                  </a:lnTo>
                  <a:lnTo>
                    <a:pt x="1101" y="823"/>
                  </a:lnTo>
                  <a:lnTo>
                    <a:pt x="1105" y="823"/>
                  </a:lnTo>
                  <a:lnTo>
                    <a:pt x="1110" y="823"/>
                  </a:lnTo>
                  <a:lnTo>
                    <a:pt x="1113" y="823"/>
                  </a:lnTo>
                  <a:lnTo>
                    <a:pt x="1117" y="823"/>
                  </a:lnTo>
                  <a:lnTo>
                    <a:pt x="1121" y="823"/>
                  </a:lnTo>
                  <a:lnTo>
                    <a:pt x="1124" y="823"/>
                  </a:lnTo>
                  <a:lnTo>
                    <a:pt x="1128" y="823"/>
                  </a:lnTo>
                  <a:lnTo>
                    <a:pt x="1132" y="823"/>
                  </a:lnTo>
                  <a:lnTo>
                    <a:pt x="1137" y="823"/>
                  </a:lnTo>
                  <a:lnTo>
                    <a:pt x="1140" y="823"/>
                  </a:lnTo>
                  <a:lnTo>
                    <a:pt x="1144" y="823"/>
                  </a:lnTo>
                  <a:lnTo>
                    <a:pt x="1148" y="823"/>
                  </a:lnTo>
                  <a:lnTo>
                    <a:pt x="1151" y="824"/>
                  </a:lnTo>
                  <a:lnTo>
                    <a:pt x="1155" y="824"/>
                  </a:lnTo>
                  <a:lnTo>
                    <a:pt x="1159" y="824"/>
                  </a:lnTo>
                  <a:lnTo>
                    <a:pt x="1163" y="824"/>
                  </a:lnTo>
                  <a:lnTo>
                    <a:pt x="1167" y="824"/>
                  </a:lnTo>
                  <a:lnTo>
                    <a:pt x="1171" y="824"/>
                  </a:lnTo>
                  <a:lnTo>
                    <a:pt x="1174" y="824"/>
                  </a:lnTo>
                  <a:lnTo>
                    <a:pt x="1178" y="824"/>
                  </a:lnTo>
                  <a:lnTo>
                    <a:pt x="1182" y="824"/>
                  </a:lnTo>
                  <a:lnTo>
                    <a:pt x="1187" y="824"/>
                  </a:lnTo>
                  <a:lnTo>
                    <a:pt x="1190" y="824"/>
                  </a:lnTo>
                  <a:lnTo>
                    <a:pt x="1194" y="824"/>
                  </a:lnTo>
                  <a:lnTo>
                    <a:pt x="1197" y="824"/>
                  </a:lnTo>
                  <a:lnTo>
                    <a:pt x="1201" y="824"/>
                  </a:lnTo>
                  <a:lnTo>
                    <a:pt x="1205" y="824"/>
                  </a:lnTo>
                  <a:lnTo>
                    <a:pt x="1208" y="824"/>
                  </a:lnTo>
                  <a:lnTo>
                    <a:pt x="1213" y="824"/>
                  </a:lnTo>
                  <a:lnTo>
                    <a:pt x="1217" y="824"/>
                  </a:lnTo>
                  <a:lnTo>
                    <a:pt x="1221" y="824"/>
                  </a:lnTo>
                  <a:lnTo>
                    <a:pt x="1224" y="825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382840" y="2073240"/>
              <a:ext cx="4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478600" y="2101680"/>
              <a:ext cx="4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518920" y="2073240"/>
              <a:ext cx="45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= 0.99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825480" y="29462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00200" y="26496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00200" y="23544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00200" y="20574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700200" y="17636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637920" y="146700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946080" y="3100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309320" y="3100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701360" y="3100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093760" y="3100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485800" y="31003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849400" y="31003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243240" y="31003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766880" y="1314360"/>
              <a:ext cx="858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ERK1/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85640" y="126036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U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694520" y="3211560"/>
              <a:ext cx="913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fold dilution)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425760" y="1368360"/>
              <a:ext cx="3094200" cy="1954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836880" y="1525680"/>
              <a:ext cx="34920" cy="1457280"/>
            </a:xfrm>
            <a:custGeom>
              <a:avLst/>
              <a:gdLst/>
              <a:ahLst/>
              <a:rect l="l" t="t" r="r" b="b"/>
              <a:pathLst>
                <a:path w="22" h="918">
                  <a:moveTo>
                    <a:pt x="0" y="0"/>
                  </a:moveTo>
                  <a:lnTo>
                    <a:pt x="0" y="918"/>
                  </a:lnTo>
                  <a:lnTo>
                    <a:pt x="22" y="918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836880" y="2690640"/>
              <a:ext cx="349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836880" y="2400480"/>
              <a:ext cx="349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836880" y="2108160"/>
              <a:ext cx="349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836880" y="1816200"/>
              <a:ext cx="349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836880" y="1525680"/>
              <a:ext cx="349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836880" y="2982960"/>
              <a:ext cx="24940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3836880" y="2947680"/>
              <a:ext cx="180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4253040" y="2947680"/>
              <a:ext cx="144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4668840" y="2947680"/>
              <a:ext cx="144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5084640" y="2947680"/>
              <a:ext cx="180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5499000" y="2947680"/>
              <a:ext cx="180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5916600" y="2947680"/>
              <a:ext cx="144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6330960" y="2947680"/>
              <a:ext cx="1440" cy="34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838680" y="1808280"/>
              <a:ext cx="55440" cy="54000"/>
            </a:xfrm>
            <a:custGeom>
              <a:avLst/>
              <a:gdLst/>
              <a:ahLst/>
              <a:rect l="l" t="t" r="r" b="b"/>
              <a:pathLst>
                <a:path w="35" h="34">
                  <a:moveTo>
                    <a:pt x="18" y="0"/>
                  </a:moveTo>
                  <a:lnTo>
                    <a:pt x="35" y="17"/>
                  </a:lnTo>
                  <a:lnTo>
                    <a:pt x="18" y="34"/>
                  </a:lnTo>
                  <a:lnTo>
                    <a:pt x="0" y="17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835440" y="180504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860640" y="230040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3855960" y="229536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027320" y="283356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022640" y="282888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897520" y="296064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894280" y="295596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3838680" y="1792440"/>
              <a:ext cx="55440" cy="54000"/>
            </a:xfrm>
            <a:custGeom>
              <a:avLst/>
              <a:gdLst/>
              <a:ahLst/>
              <a:rect l="l" t="t" r="r" b="b"/>
              <a:pathLst>
                <a:path w="35" h="34">
                  <a:moveTo>
                    <a:pt x="18" y="0"/>
                  </a:moveTo>
                  <a:lnTo>
                    <a:pt x="35" y="17"/>
                  </a:lnTo>
                  <a:lnTo>
                    <a:pt x="18" y="34"/>
                  </a:lnTo>
                  <a:lnTo>
                    <a:pt x="0" y="17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835440" y="178740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860640" y="228276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855960" y="227952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027320" y="281628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022640" y="281304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897520" y="294336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894280" y="2940120"/>
              <a:ext cx="54000" cy="54000"/>
            </a:xfrm>
            <a:custGeom>
              <a:avLst/>
              <a:gdLst/>
              <a:ahLst/>
              <a:rect l="l" t="t" r="r" b="b"/>
              <a:pathLst>
                <a:path w="34" h="34">
                  <a:moveTo>
                    <a:pt x="17" y="0"/>
                  </a:moveTo>
                  <a:lnTo>
                    <a:pt x="34" y="17"/>
                  </a:lnTo>
                  <a:lnTo>
                    <a:pt x="17" y="34"/>
                  </a:lnTo>
                  <a:lnTo>
                    <a:pt x="0" y="17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3857760" y="1793880"/>
              <a:ext cx="2058840" cy="1168560"/>
            </a:xfrm>
            <a:custGeom>
              <a:avLst/>
              <a:gdLst/>
              <a:ahLst/>
              <a:rect l="l" t="t" r="r" b="b"/>
              <a:pathLst>
                <a:path w="1297" h="736">
                  <a:moveTo>
                    <a:pt x="0" y="0"/>
                  </a:moveTo>
                  <a:lnTo>
                    <a:pt x="4" y="169"/>
                  </a:lnTo>
                  <a:lnTo>
                    <a:pt x="9" y="273"/>
                  </a:lnTo>
                  <a:lnTo>
                    <a:pt x="13" y="344"/>
                  </a:lnTo>
                  <a:lnTo>
                    <a:pt x="17" y="395"/>
                  </a:lnTo>
                  <a:lnTo>
                    <a:pt x="23" y="434"/>
                  </a:lnTo>
                  <a:lnTo>
                    <a:pt x="27" y="466"/>
                  </a:lnTo>
                  <a:lnTo>
                    <a:pt x="31" y="491"/>
                  </a:lnTo>
                  <a:lnTo>
                    <a:pt x="36" y="512"/>
                  </a:lnTo>
                  <a:lnTo>
                    <a:pt x="40" y="529"/>
                  </a:lnTo>
                  <a:lnTo>
                    <a:pt x="44" y="544"/>
                  </a:lnTo>
                  <a:lnTo>
                    <a:pt x="49" y="558"/>
                  </a:lnTo>
                  <a:lnTo>
                    <a:pt x="53" y="568"/>
                  </a:lnTo>
                  <a:lnTo>
                    <a:pt x="57" y="579"/>
                  </a:lnTo>
                  <a:lnTo>
                    <a:pt x="62" y="588"/>
                  </a:lnTo>
                  <a:lnTo>
                    <a:pt x="66" y="596"/>
                  </a:lnTo>
                  <a:lnTo>
                    <a:pt x="70" y="602"/>
                  </a:lnTo>
                  <a:lnTo>
                    <a:pt x="75" y="609"/>
                  </a:lnTo>
                  <a:lnTo>
                    <a:pt x="79" y="615"/>
                  </a:lnTo>
                  <a:lnTo>
                    <a:pt x="84" y="621"/>
                  </a:lnTo>
                  <a:lnTo>
                    <a:pt x="88" y="624"/>
                  </a:lnTo>
                  <a:lnTo>
                    <a:pt x="92" y="630"/>
                  </a:lnTo>
                  <a:lnTo>
                    <a:pt x="98" y="634"/>
                  </a:lnTo>
                  <a:lnTo>
                    <a:pt x="101" y="638"/>
                  </a:lnTo>
                  <a:lnTo>
                    <a:pt x="105" y="642"/>
                  </a:lnTo>
                  <a:lnTo>
                    <a:pt x="111" y="645"/>
                  </a:lnTo>
                  <a:lnTo>
                    <a:pt x="115" y="648"/>
                  </a:lnTo>
                  <a:lnTo>
                    <a:pt x="119" y="651"/>
                  </a:lnTo>
                  <a:lnTo>
                    <a:pt x="124" y="653"/>
                  </a:lnTo>
                  <a:lnTo>
                    <a:pt x="128" y="656"/>
                  </a:lnTo>
                  <a:lnTo>
                    <a:pt x="132" y="659"/>
                  </a:lnTo>
                  <a:lnTo>
                    <a:pt x="137" y="661"/>
                  </a:lnTo>
                  <a:lnTo>
                    <a:pt x="141" y="664"/>
                  </a:lnTo>
                  <a:lnTo>
                    <a:pt x="145" y="665"/>
                  </a:lnTo>
                  <a:lnTo>
                    <a:pt x="150" y="668"/>
                  </a:lnTo>
                  <a:lnTo>
                    <a:pt x="154" y="669"/>
                  </a:lnTo>
                  <a:lnTo>
                    <a:pt x="158" y="672"/>
                  </a:lnTo>
                  <a:lnTo>
                    <a:pt x="163" y="673"/>
                  </a:lnTo>
                  <a:lnTo>
                    <a:pt x="167" y="674"/>
                  </a:lnTo>
                  <a:lnTo>
                    <a:pt x="171" y="676"/>
                  </a:lnTo>
                  <a:lnTo>
                    <a:pt x="176" y="678"/>
                  </a:lnTo>
                  <a:lnTo>
                    <a:pt x="180" y="680"/>
                  </a:lnTo>
                  <a:lnTo>
                    <a:pt x="184" y="681"/>
                  </a:lnTo>
                  <a:lnTo>
                    <a:pt x="189" y="682"/>
                  </a:lnTo>
                  <a:lnTo>
                    <a:pt x="193" y="684"/>
                  </a:lnTo>
                  <a:lnTo>
                    <a:pt x="197" y="685"/>
                  </a:lnTo>
                  <a:lnTo>
                    <a:pt x="203" y="685"/>
                  </a:lnTo>
                  <a:lnTo>
                    <a:pt x="207" y="686"/>
                  </a:lnTo>
                  <a:lnTo>
                    <a:pt x="212" y="687"/>
                  </a:lnTo>
                  <a:lnTo>
                    <a:pt x="216" y="689"/>
                  </a:lnTo>
                  <a:lnTo>
                    <a:pt x="220" y="690"/>
                  </a:lnTo>
                  <a:lnTo>
                    <a:pt x="225" y="690"/>
                  </a:lnTo>
                  <a:lnTo>
                    <a:pt x="229" y="691"/>
                  </a:lnTo>
                  <a:lnTo>
                    <a:pt x="233" y="693"/>
                  </a:lnTo>
                  <a:lnTo>
                    <a:pt x="238" y="693"/>
                  </a:lnTo>
                  <a:lnTo>
                    <a:pt x="242" y="694"/>
                  </a:lnTo>
                  <a:lnTo>
                    <a:pt x="246" y="695"/>
                  </a:lnTo>
                  <a:lnTo>
                    <a:pt x="251" y="695"/>
                  </a:lnTo>
                  <a:lnTo>
                    <a:pt x="255" y="697"/>
                  </a:lnTo>
                  <a:lnTo>
                    <a:pt x="259" y="698"/>
                  </a:lnTo>
                  <a:lnTo>
                    <a:pt x="264" y="698"/>
                  </a:lnTo>
                  <a:lnTo>
                    <a:pt x="268" y="699"/>
                  </a:lnTo>
                  <a:lnTo>
                    <a:pt x="272" y="699"/>
                  </a:lnTo>
                  <a:lnTo>
                    <a:pt x="277" y="701"/>
                  </a:lnTo>
                  <a:lnTo>
                    <a:pt x="281" y="701"/>
                  </a:lnTo>
                  <a:lnTo>
                    <a:pt x="285" y="702"/>
                  </a:lnTo>
                  <a:lnTo>
                    <a:pt x="291" y="702"/>
                  </a:lnTo>
                  <a:lnTo>
                    <a:pt x="295" y="703"/>
                  </a:lnTo>
                  <a:lnTo>
                    <a:pt x="299" y="703"/>
                  </a:lnTo>
                  <a:lnTo>
                    <a:pt x="304" y="703"/>
                  </a:lnTo>
                  <a:lnTo>
                    <a:pt x="308" y="705"/>
                  </a:lnTo>
                  <a:lnTo>
                    <a:pt x="312" y="705"/>
                  </a:lnTo>
                  <a:lnTo>
                    <a:pt x="317" y="706"/>
                  </a:lnTo>
                  <a:lnTo>
                    <a:pt x="321" y="706"/>
                  </a:lnTo>
                  <a:lnTo>
                    <a:pt x="325" y="706"/>
                  </a:lnTo>
                  <a:lnTo>
                    <a:pt x="330" y="707"/>
                  </a:lnTo>
                  <a:lnTo>
                    <a:pt x="334" y="707"/>
                  </a:lnTo>
                  <a:lnTo>
                    <a:pt x="339" y="707"/>
                  </a:lnTo>
                  <a:lnTo>
                    <a:pt x="343" y="708"/>
                  </a:lnTo>
                  <a:lnTo>
                    <a:pt x="347" y="708"/>
                  </a:lnTo>
                  <a:lnTo>
                    <a:pt x="352" y="708"/>
                  </a:lnTo>
                  <a:lnTo>
                    <a:pt x="356" y="710"/>
                  </a:lnTo>
                  <a:lnTo>
                    <a:pt x="360" y="710"/>
                  </a:lnTo>
                  <a:lnTo>
                    <a:pt x="366" y="710"/>
                  </a:lnTo>
                  <a:lnTo>
                    <a:pt x="369" y="711"/>
                  </a:lnTo>
                  <a:lnTo>
                    <a:pt x="373" y="711"/>
                  </a:lnTo>
                  <a:lnTo>
                    <a:pt x="379" y="711"/>
                  </a:lnTo>
                  <a:lnTo>
                    <a:pt x="383" y="712"/>
                  </a:lnTo>
                  <a:lnTo>
                    <a:pt x="387" y="712"/>
                  </a:lnTo>
                  <a:lnTo>
                    <a:pt x="392" y="712"/>
                  </a:lnTo>
                  <a:lnTo>
                    <a:pt x="396" y="712"/>
                  </a:lnTo>
                  <a:lnTo>
                    <a:pt x="400" y="714"/>
                  </a:lnTo>
                  <a:lnTo>
                    <a:pt x="405" y="714"/>
                  </a:lnTo>
                  <a:lnTo>
                    <a:pt x="409" y="714"/>
                  </a:lnTo>
                  <a:lnTo>
                    <a:pt x="413" y="714"/>
                  </a:lnTo>
                  <a:lnTo>
                    <a:pt x="418" y="715"/>
                  </a:lnTo>
                  <a:lnTo>
                    <a:pt x="422" y="715"/>
                  </a:lnTo>
                  <a:lnTo>
                    <a:pt x="426" y="715"/>
                  </a:lnTo>
                  <a:lnTo>
                    <a:pt x="431" y="715"/>
                  </a:lnTo>
                  <a:lnTo>
                    <a:pt x="435" y="716"/>
                  </a:lnTo>
                  <a:lnTo>
                    <a:pt x="439" y="716"/>
                  </a:lnTo>
                  <a:lnTo>
                    <a:pt x="444" y="716"/>
                  </a:lnTo>
                  <a:lnTo>
                    <a:pt x="448" y="716"/>
                  </a:lnTo>
                  <a:lnTo>
                    <a:pt x="452" y="716"/>
                  </a:lnTo>
                  <a:lnTo>
                    <a:pt x="457" y="718"/>
                  </a:lnTo>
                  <a:lnTo>
                    <a:pt x="461" y="718"/>
                  </a:lnTo>
                  <a:lnTo>
                    <a:pt x="467" y="718"/>
                  </a:lnTo>
                  <a:lnTo>
                    <a:pt x="471" y="718"/>
                  </a:lnTo>
                  <a:lnTo>
                    <a:pt x="475" y="718"/>
                  </a:lnTo>
                  <a:lnTo>
                    <a:pt x="480" y="719"/>
                  </a:lnTo>
                  <a:lnTo>
                    <a:pt x="484" y="719"/>
                  </a:lnTo>
                  <a:lnTo>
                    <a:pt x="488" y="719"/>
                  </a:lnTo>
                  <a:lnTo>
                    <a:pt x="493" y="719"/>
                  </a:lnTo>
                  <a:lnTo>
                    <a:pt x="497" y="719"/>
                  </a:lnTo>
                  <a:lnTo>
                    <a:pt x="501" y="719"/>
                  </a:lnTo>
                  <a:lnTo>
                    <a:pt x="506" y="720"/>
                  </a:lnTo>
                  <a:lnTo>
                    <a:pt x="510" y="720"/>
                  </a:lnTo>
                  <a:lnTo>
                    <a:pt x="514" y="720"/>
                  </a:lnTo>
                  <a:lnTo>
                    <a:pt x="519" y="720"/>
                  </a:lnTo>
                  <a:lnTo>
                    <a:pt x="523" y="720"/>
                  </a:lnTo>
                  <a:lnTo>
                    <a:pt x="527" y="720"/>
                  </a:lnTo>
                  <a:lnTo>
                    <a:pt x="532" y="722"/>
                  </a:lnTo>
                  <a:lnTo>
                    <a:pt x="536" y="722"/>
                  </a:lnTo>
                  <a:lnTo>
                    <a:pt x="540" y="722"/>
                  </a:lnTo>
                  <a:lnTo>
                    <a:pt x="546" y="722"/>
                  </a:lnTo>
                  <a:lnTo>
                    <a:pt x="549" y="722"/>
                  </a:lnTo>
                  <a:lnTo>
                    <a:pt x="553" y="722"/>
                  </a:lnTo>
                  <a:lnTo>
                    <a:pt x="559" y="722"/>
                  </a:lnTo>
                  <a:lnTo>
                    <a:pt x="563" y="723"/>
                  </a:lnTo>
                  <a:lnTo>
                    <a:pt x="567" y="723"/>
                  </a:lnTo>
                  <a:lnTo>
                    <a:pt x="572" y="723"/>
                  </a:lnTo>
                  <a:lnTo>
                    <a:pt x="576" y="723"/>
                  </a:lnTo>
                  <a:lnTo>
                    <a:pt x="580" y="723"/>
                  </a:lnTo>
                  <a:lnTo>
                    <a:pt x="585" y="723"/>
                  </a:lnTo>
                  <a:lnTo>
                    <a:pt x="589" y="723"/>
                  </a:lnTo>
                  <a:lnTo>
                    <a:pt x="594" y="723"/>
                  </a:lnTo>
                  <a:lnTo>
                    <a:pt x="598" y="724"/>
                  </a:lnTo>
                  <a:lnTo>
                    <a:pt x="602" y="724"/>
                  </a:lnTo>
                  <a:lnTo>
                    <a:pt x="607" y="724"/>
                  </a:lnTo>
                  <a:lnTo>
                    <a:pt x="611" y="724"/>
                  </a:lnTo>
                  <a:lnTo>
                    <a:pt x="615" y="724"/>
                  </a:lnTo>
                  <a:lnTo>
                    <a:pt x="620" y="724"/>
                  </a:lnTo>
                  <a:lnTo>
                    <a:pt x="624" y="724"/>
                  </a:lnTo>
                  <a:lnTo>
                    <a:pt x="628" y="724"/>
                  </a:lnTo>
                  <a:lnTo>
                    <a:pt x="634" y="726"/>
                  </a:lnTo>
                  <a:lnTo>
                    <a:pt x="637" y="726"/>
                  </a:lnTo>
                  <a:lnTo>
                    <a:pt x="641" y="726"/>
                  </a:lnTo>
                  <a:lnTo>
                    <a:pt x="647" y="726"/>
                  </a:lnTo>
                  <a:lnTo>
                    <a:pt x="651" y="726"/>
                  </a:lnTo>
                  <a:lnTo>
                    <a:pt x="655" y="726"/>
                  </a:lnTo>
                  <a:lnTo>
                    <a:pt x="660" y="726"/>
                  </a:lnTo>
                  <a:lnTo>
                    <a:pt x="664" y="726"/>
                  </a:lnTo>
                  <a:lnTo>
                    <a:pt x="668" y="726"/>
                  </a:lnTo>
                  <a:lnTo>
                    <a:pt x="673" y="726"/>
                  </a:lnTo>
                  <a:lnTo>
                    <a:pt x="677" y="727"/>
                  </a:lnTo>
                  <a:lnTo>
                    <a:pt x="681" y="727"/>
                  </a:lnTo>
                  <a:lnTo>
                    <a:pt x="686" y="727"/>
                  </a:lnTo>
                  <a:lnTo>
                    <a:pt x="690" y="727"/>
                  </a:lnTo>
                  <a:lnTo>
                    <a:pt x="694" y="727"/>
                  </a:lnTo>
                  <a:lnTo>
                    <a:pt x="699" y="727"/>
                  </a:lnTo>
                  <a:lnTo>
                    <a:pt x="703" y="727"/>
                  </a:lnTo>
                  <a:lnTo>
                    <a:pt x="707" y="727"/>
                  </a:lnTo>
                  <a:lnTo>
                    <a:pt x="712" y="727"/>
                  </a:lnTo>
                  <a:lnTo>
                    <a:pt x="716" y="727"/>
                  </a:lnTo>
                  <a:lnTo>
                    <a:pt x="722" y="728"/>
                  </a:lnTo>
                  <a:lnTo>
                    <a:pt x="725" y="728"/>
                  </a:lnTo>
                  <a:lnTo>
                    <a:pt x="729" y="728"/>
                  </a:lnTo>
                  <a:lnTo>
                    <a:pt x="735" y="728"/>
                  </a:lnTo>
                  <a:lnTo>
                    <a:pt x="739" y="728"/>
                  </a:lnTo>
                  <a:lnTo>
                    <a:pt x="743" y="728"/>
                  </a:lnTo>
                  <a:lnTo>
                    <a:pt x="748" y="728"/>
                  </a:lnTo>
                  <a:lnTo>
                    <a:pt x="752" y="728"/>
                  </a:lnTo>
                  <a:lnTo>
                    <a:pt x="756" y="728"/>
                  </a:lnTo>
                  <a:lnTo>
                    <a:pt x="761" y="728"/>
                  </a:lnTo>
                  <a:lnTo>
                    <a:pt x="765" y="728"/>
                  </a:lnTo>
                  <a:lnTo>
                    <a:pt x="769" y="728"/>
                  </a:lnTo>
                  <a:lnTo>
                    <a:pt x="774" y="728"/>
                  </a:lnTo>
                  <a:lnTo>
                    <a:pt x="778" y="729"/>
                  </a:lnTo>
                  <a:lnTo>
                    <a:pt x="782" y="729"/>
                  </a:lnTo>
                  <a:lnTo>
                    <a:pt x="787" y="729"/>
                  </a:lnTo>
                  <a:lnTo>
                    <a:pt x="791" y="729"/>
                  </a:lnTo>
                  <a:lnTo>
                    <a:pt x="795" y="729"/>
                  </a:lnTo>
                  <a:lnTo>
                    <a:pt x="800" y="729"/>
                  </a:lnTo>
                  <a:lnTo>
                    <a:pt x="804" y="729"/>
                  </a:lnTo>
                  <a:lnTo>
                    <a:pt x="808" y="729"/>
                  </a:lnTo>
                  <a:lnTo>
                    <a:pt x="814" y="729"/>
                  </a:lnTo>
                  <a:lnTo>
                    <a:pt x="817" y="729"/>
                  </a:lnTo>
                  <a:lnTo>
                    <a:pt x="821" y="729"/>
                  </a:lnTo>
                  <a:lnTo>
                    <a:pt x="827" y="729"/>
                  </a:lnTo>
                  <a:lnTo>
                    <a:pt x="831" y="729"/>
                  </a:lnTo>
                  <a:lnTo>
                    <a:pt x="835" y="729"/>
                  </a:lnTo>
                  <a:lnTo>
                    <a:pt x="840" y="731"/>
                  </a:lnTo>
                  <a:lnTo>
                    <a:pt x="844" y="731"/>
                  </a:lnTo>
                  <a:lnTo>
                    <a:pt x="849" y="731"/>
                  </a:lnTo>
                  <a:lnTo>
                    <a:pt x="853" y="731"/>
                  </a:lnTo>
                  <a:lnTo>
                    <a:pt x="857" y="731"/>
                  </a:lnTo>
                  <a:lnTo>
                    <a:pt x="862" y="731"/>
                  </a:lnTo>
                  <a:lnTo>
                    <a:pt x="866" y="731"/>
                  </a:lnTo>
                  <a:lnTo>
                    <a:pt x="870" y="731"/>
                  </a:lnTo>
                  <a:lnTo>
                    <a:pt x="875" y="731"/>
                  </a:lnTo>
                  <a:lnTo>
                    <a:pt x="879" y="731"/>
                  </a:lnTo>
                  <a:lnTo>
                    <a:pt x="883" y="731"/>
                  </a:lnTo>
                  <a:lnTo>
                    <a:pt x="888" y="731"/>
                  </a:lnTo>
                  <a:lnTo>
                    <a:pt x="892" y="731"/>
                  </a:lnTo>
                  <a:lnTo>
                    <a:pt x="896" y="731"/>
                  </a:lnTo>
                  <a:lnTo>
                    <a:pt x="902" y="731"/>
                  </a:lnTo>
                  <a:lnTo>
                    <a:pt x="905" y="731"/>
                  </a:lnTo>
                  <a:lnTo>
                    <a:pt x="909" y="732"/>
                  </a:lnTo>
                  <a:lnTo>
                    <a:pt x="915" y="732"/>
                  </a:lnTo>
                  <a:lnTo>
                    <a:pt x="919" y="732"/>
                  </a:lnTo>
                  <a:lnTo>
                    <a:pt x="923" y="732"/>
                  </a:lnTo>
                  <a:lnTo>
                    <a:pt x="928" y="732"/>
                  </a:lnTo>
                  <a:lnTo>
                    <a:pt x="932" y="732"/>
                  </a:lnTo>
                  <a:lnTo>
                    <a:pt x="936" y="732"/>
                  </a:lnTo>
                  <a:lnTo>
                    <a:pt x="941" y="732"/>
                  </a:lnTo>
                  <a:lnTo>
                    <a:pt x="945" y="732"/>
                  </a:lnTo>
                  <a:lnTo>
                    <a:pt x="949" y="732"/>
                  </a:lnTo>
                  <a:lnTo>
                    <a:pt x="954" y="732"/>
                  </a:lnTo>
                  <a:lnTo>
                    <a:pt x="958" y="732"/>
                  </a:lnTo>
                  <a:lnTo>
                    <a:pt x="962" y="732"/>
                  </a:lnTo>
                  <a:lnTo>
                    <a:pt x="967" y="732"/>
                  </a:lnTo>
                  <a:lnTo>
                    <a:pt x="971" y="732"/>
                  </a:lnTo>
                  <a:lnTo>
                    <a:pt x="976" y="732"/>
                  </a:lnTo>
                  <a:lnTo>
                    <a:pt x="980" y="732"/>
                  </a:lnTo>
                  <a:lnTo>
                    <a:pt x="984" y="732"/>
                  </a:lnTo>
                  <a:lnTo>
                    <a:pt x="990" y="732"/>
                  </a:lnTo>
                  <a:lnTo>
                    <a:pt x="994" y="733"/>
                  </a:lnTo>
                  <a:lnTo>
                    <a:pt x="997" y="733"/>
                  </a:lnTo>
                  <a:lnTo>
                    <a:pt x="1003" y="733"/>
                  </a:lnTo>
                  <a:lnTo>
                    <a:pt x="1007" y="733"/>
                  </a:lnTo>
                  <a:lnTo>
                    <a:pt x="1011" y="733"/>
                  </a:lnTo>
                  <a:lnTo>
                    <a:pt x="1016" y="733"/>
                  </a:lnTo>
                  <a:lnTo>
                    <a:pt x="1020" y="733"/>
                  </a:lnTo>
                  <a:lnTo>
                    <a:pt x="1024" y="733"/>
                  </a:lnTo>
                  <a:lnTo>
                    <a:pt x="1029" y="733"/>
                  </a:lnTo>
                  <a:lnTo>
                    <a:pt x="1033" y="733"/>
                  </a:lnTo>
                  <a:lnTo>
                    <a:pt x="1037" y="733"/>
                  </a:lnTo>
                  <a:lnTo>
                    <a:pt x="1042" y="733"/>
                  </a:lnTo>
                  <a:lnTo>
                    <a:pt x="1046" y="733"/>
                  </a:lnTo>
                  <a:lnTo>
                    <a:pt x="1050" y="733"/>
                  </a:lnTo>
                  <a:lnTo>
                    <a:pt x="1055" y="733"/>
                  </a:lnTo>
                  <a:lnTo>
                    <a:pt x="1059" y="733"/>
                  </a:lnTo>
                  <a:lnTo>
                    <a:pt x="1063" y="733"/>
                  </a:lnTo>
                  <a:lnTo>
                    <a:pt x="1068" y="733"/>
                  </a:lnTo>
                  <a:lnTo>
                    <a:pt x="1072" y="733"/>
                  </a:lnTo>
                  <a:lnTo>
                    <a:pt x="1076" y="733"/>
                  </a:lnTo>
                  <a:lnTo>
                    <a:pt x="1082" y="733"/>
                  </a:lnTo>
                  <a:lnTo>
                    <a:pt x="1085" y="733"/>
                  </a:lnTo>
                  <a:lnTo>
                    <a:pt x="1089" y="733"/>
                  </a:lnTo>
                  <a:lnTo>
                    <a:pt x="1095" y="735"/>
                  </a:lnTo>
                  <a:lnTo>
                    <a:pt x="1099" y="735"/>
                  </a:lnTo>
                  <a:lnTo>
                    <a:pt x="1103" y="735"/>
                  </a:lnTo>
                  <a:lnTo>
                    <a:pt x="1108" y="735"/>
                  </a:lnTo>
                  <a:lnTo>
                    <a:pt x="1112" y="735"/>
                  </a:lnTo>
                  <a:lnTo>
                    <a:pt x="1117" y="735"/>
                  </a:lnTo>
                  <a:lnTo>
                    <a:pt x="1121" y="735"/>
                  </a:lnTo>
                  <a:lnTo>
                    <a:pt x="1125" y="735"/>
                  </a:lnTo>
                  <a:lnTo>
                    <a:pt x="1130" y="735"/>
                  </a:lnTo>
                  <a:lnTo>
                    <a:pt x="1134" y="735"/>
                  </a:lnTo>
                  <a:lnTo>
                    <a:pt x="1138" y="735"/>
                  </a:lnTo>
                  <a:lnTo>
                    <a:pt x="1143" y="735"/>
                  </a:lnTo>
                  <a:lnTo>
                    <a:pt x="1147" y="735"/>
                  </a:lnTo>
                  <a:lnTo>
                    <a:pt x="1151" y="735"/>
                  </a:lnTo>
                  <a:lnTo>
                    <a:pt x="1156" y="735"/>
                  </a:lnTo>
                  <a:lnTo>
                    <a:pt x="1160" y="735"/>
                  </a:lnTo>
                  <a:lnTo>
                    <a:pt x="1164" y="735"/>
                  </a:lnTo>
                  <a:lnTo>
                    <a:pt x="1170" y="735"/>
                  </a:lnTo>
                  <a:lnTo>
                    <a:pt x="1173" y="735"/>
                  </a:lnTo>
                  <a:lnTo>
                    <a:pt x="1177" y="735"/>
                  </a:lnTo>
                  <a:lnTo>
                    <a:pt x="1183" y="735"/>
                  </a:lnTo>
                  <a:lnTo>
                    <a:pt x="1187" y="735"/>
                  </a:lnTo>
                  <a:lnTo>
                    <a:pt x="1191" y="735"/>
                  </a:lnTo>
                  <a:lnTo>
                    <a:pt x="1196" y="735"/>
                  </a:lnTo>
                  <a:lnTo>
                    <a:pt x="1200" y="735"/>
                  </a:lnTo>
                  <a:lnTo>
                    <a:pt x="1204" y="735"/>
                  </a:lnTo>
                  <a:lnTo>
                    <a:pt x="1209" y="735"/>
                  </a:lnTo>
                  <a:lnTo>
                    <a:pt x="1213" y="735"/>
                  </a:lnTo>
                  <a:lnTo>
                    <a:pt x="1217" y="736"/>
                  </a:lnTo>
                  <a:lnTo>
                    <a:pt x="1222" y="736"/>
                  </a:lnTo>
                  <a:lnTo>
                    <a:pt x="1226" y="736"/>
                  </a:lnTo>
                  <a:lnTo>
                    <a:pt x="1230" y="736"/>
                  </a:lnTo>
                  <a:lnTo>
                    <a:pt x="1235" y="736"/>
                  </a:lnTo>
                  <a:lnTo>
                    <a:pt x="1239" y="736"/>
                  </a:lnTo>
                  <a:lnTo>
                    <a:pt x="1244" y="736"/>
                  </a:lnTo>
                  <a:lnTo>
                    <a:pt x="1248" y="736"/>
                  </a:lnTo>
                  <a:lnTo>
                    <a:pt x="1252" y="736"/>
                  </a:lnTo>
                  <a:lnTo>
                    <a:pt x="1258" y="736"/>
                  </a:lnTo>
                  <a:lnTo>
                    <a:pt x="1262" y="736"/>
                  </a:lnTo>
                  <a:lnTo>
                    <a:pt x="1265" y="736"/>
                  </a:lnTo>
                  <a:lnTo>
                    <a:pt x="1271" y="736"/>
                  </a:lnTo>
                  <a:lnTo>
                    <a:pt x="1275" y="736"/>
                  </a:lnTo>
                  <a:lnTo>
                    <a:pt x="1279" y="736"/>
                  </a:lnTo>
                  <a:lnTo>
                    <a:pt x="1284" y="736"/>
                  </a:lnTo>
                  <a:lnTo>
                    <a:pt x="1288" y="736"/>
                  </a:lnTo>
                  <a:lnTo>
                    <a:pt x="1292" y="736"/>
                  </a:lnTo>
                  <a:lnTo>
                    <a:pt x="1297" y="736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398920" y="2028960"/>
              <a:ext cx="4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490000" y="2058840"/>
              <a:ext cx="4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528880" y="2028960"/>
              <a:ext cx="45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= 0.99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3700440" y="2925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3575160" y="26337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3575160" y="23414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575160" y="20509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3575160" y="17589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3511080" y="1467000"/>
              <a:ext cx="226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814920" y="30877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198680" y="3087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614480" y="3087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030640" y="3087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444640" y="308772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830920" y="30877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6246720" y="30877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772160" y="1282680"/>
              <a:ext cx="74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MEK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386160" y="126216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U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645440" y="3219480"/>
              <a:ext cx="913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fold dilution)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498840" y="3676680"/>
              <a:ext cx="2978280" cy="1817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827520" y="3776760"/>
              <a:ext cx="33120" cy="1461960"/>
            </a:xfrm>
            <a:custGeom>
              <a:avLst/>
              <a:gdLst/>
              <a:ahLst/>
              <a:rect l="l" t="t" r="r" b="b"/>
              <a:pathLst>
                <a:path w="21" h="921">
                  <a:moveTo>
                    <a:pt x="0" y="0"/>
                  </a:moveTo>
                  <a:lnTo>
                    <a:pt x="0" y="921"/>
                  </a:lnTo>
                  <a:lnTo>
                    <a:pt x="21" y="921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3827520" y="4946760"/>
              <a:ext cx="33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827520" y="4653000"/>
              <a:ext cx="33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827520" y="4362480"/>
              <a:ext cx="33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827520" y="4070520"/>
              <a:ext cx="33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827520" y="3776760"/>
              <a:ext cx="33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3827520" y="5238720"/>
              <a:ext cx="23637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3827520" y="520488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 flipV="1">
              <a:off x="4221000" y="5204880"/>
              <a:ext cx="180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616280" y="5204880"/>
              <a:ext cx="180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5010120" y="520488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5403960" y="520488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 flipV="1">
              <a:off x="5797440" y="5204880"/>
              <a:ext cx="180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6191280" y="520488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3830760" y="3965400"/>
              <a:ext cx="50760" cy="5112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825720" y="3962520"/>
              <a:ext cx="5112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849840" y="4487760"/>
              <a:ext cx="50760" cy="52560"/>
            </a:xfrm>
            <a:custGeom>
              <a:avLst/>
              <a:gdLst/>
              <a:ahLst/>
              <a:rect l="l" t="t" r="r" b="b"/>
              <a:pathLst>
                <a:path w="32" h="33">
                  <a:moveTo>
                    <a:pt x="16" y="0"/>
                  </a:moveTo>
                  <a:lnTo>
                    <a:pt x="32" y="16"/>
                  </a:lnTo>
                  <a:lnTo>
                    <a:pt x="16" y="33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844800" y="4484520"/>
              <a:ext cx="52560" cy="51120"/>
            </a:xfrm>
            <a:custGeom>
              <a:avLst/>
              <a:gdLst/>
              <a:ahLst/>
              <a:rect l="l" t="t" r="r" b="b"/>
              <a:pathLst>
                <a:path w="33" h="32">
                  <a:moveTo>
                    <a:pt x="17" y="0"/>
                  </a:moveTo>
                  <a:lnTo>
                    <a:pt x="33" y="16"/>
                  </a:lnTo>
                  <a:lnTo>
                    <a:pt x="17" y="32"/>
                  </a:lnTo>
                  <a:lnTo>
                    <a:pt x="0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006800" y="501336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003560" y="5008680"/>
              <a:ext cx="50760" cy="52200"/>
            </a:xfrm>
            <a:custGeom>
              <a:avLst/>
              <a:gdLst/>
              <a:ahLst/>
              <a:rect l="l" t="t" r="r" b="b"/>
              <a:pathLst>
                <a:path w="32" h="33">
                  <a:moveTo>
                    <a:pt x="16" y="0"/>
                  </a:moveTo>
                  <a:lnTo>
                    <a:pt x="32" y="17"/>
                  </a:lnTo>
                  <a:lnTo>
                    <a:pt x="16" y="33"/>
                  </a:lnTo>
                  <a:lnTo>
                    <a:pt x="0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780160" y="517860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7f7f7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775480" y="5173560"/>
              <a:ext cx="52200" cy="52560"/>
            </a:xfrm>
            <a:custGeom>
              <a:avLst/>
              <a:gdLst/>
              <a:ahLst/>
              <a:rect l="l" t="t" r="r" b="b"/>
              <a:pathLst>
                <a:path w="33" h="33">
                  <a:moveTo>
                    <a:pt x="16" y="0"/>
                  </a:moveTo>
                  <a:lnTo>
                    <a:pt x="33" y="16"/>
                  </a:lnTo>
                  <a:lnTo>
                    <a:pt x="16" y="33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7f7f7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830760" y="3949560"/>
              <a:ext cx="50760" cy="5112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825720" y="3946680"/>
              <a:ext cx="5112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849840" y="4471920"/>
              <a:ext cx="50760" cy="52560"/>
            </a:xfrm>
            <a:custGeom>
              <a:avLst/>
              <a:gdLst/>
              <a:ahLst/>
              <a:rect l="l" t="t" r="r" b="b"/>
              <a:pathLst>
                <a:path w="32" h="33">
                  <a:moveTo>
                    <a:pt x="16" y="0"/>
                  </a:moveTo>
                  <a:lnTo>
                    <a:pt x="32" y="17"/>
                  </a:lnTo>
                  <a:lnTo>
                    <a:pt x="16" y="33"/>
                  </a:lnTo>
                  <a:lnTo>
                    <a:pt x="0" y="17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844800" y="4468680"/>
              <a:ext cx="52560" cy="50760"/>
            </a:xfrm>
            <a:custGeom>
              <a:avLst/>
              <a:gdLst/>
              <a:ahLst/>
              <a:rect l="l" t="t" r="r" b="b"/>
              <a:pathLst>
                <a:path w="33" h="32">
                  <a:moveTo>
                    <a:pt x="17" y="0"/>
                  </a:moveTo>
                  <a:lnTo>
                    <a:pt x="33" y="16"/>
                  </a:lnTo>
                  <a:lnTo>
                    <a:pt x="17" y="32"/>
                  </a:lnTo>
                  <a:lnTo>
                    <a:pt x="0" y="16"/>
                  </a:lnTo>
                  <a:lnTo>
                    <a:pt x="17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006800" y="499752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003560" y="4994280"/>
              <a:ext cx="50760" cy="507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780160" y="5162400"/>
              <a:ext cx="50760" cy="5112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63aafe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775480" y="5157720"/>
              <a:ext cx="52200" cy="52560"/>
            </a:xfrm>
            <a:custGeom>
              <a:avLst/>
              <a:gdLst/>
              <a:ahLst/>
              <a:rect l="l" t="t" r="r" b="b"/>
              <a:pathLst>
                <a:path w="33" h="33">
                  <a:moveTo>
                    <a:pt x="16" y="0"/>
                  </a:moveTo>
                  <a:lnTo>
                    <a:pt x="33" y="17"/>
                  </a:lnTo>
                  <a:lnTo>
                    <a:pt x="16" y="33"/>
                  </a:lnTo>
                  <a:lnTo>
                    <a:pt x="0" y="17"/>
                  </a:lnTo>
                  <a:lnTo>
                    <a:pt x="16" y="0"/>
                  </a:lnTo>
                  <a:close/>
                </a:path>
              </a:pathLst>
            </a:custGeom>
            <a:noFill/>
            <a:ln w="9360">
              <a:solidFill>
                <a:srgbClr val="63aaf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3848040" y="4048200"/>
              <a:ext cx="1949400" cy="1136520"/>
            </a:xfrm>
            <a:custGeom>
              <a:avLst/>
              <a:gdLst/>
              <a:ahLst/>
              <a:rect l="l" t="t" r="r" b="b"/>
              <a:pathLst>
                <a:path w="1228" h="716">
                  <a:moveTo>
                    <a:pt x="0" y="0"/>
                  </a:moveTo>
                  <a:lnTo>
                    <a:pt x="3" y="130"/>
                  </a:lnTo>
                  <a:lnTo>
                    <a:pt x="8" y="215"/>
                  </a:lnTo>
                  <a:lnTo>
                    <a:pt x="12" y="276"/>
                  </a:lnTo>
                  <a:lnTo>
                    <a:pt x="16" y="323"/>
                  </a:lnTo>
                  <a:lnTo>
                    <a:pt x="20" y="359"/>
                  </a:lnTo>
                  <a:lnTo>
                    <a:pt x="24" y="389"/>
                  </a:lnTo>
                  <a:lnTo>
                    <a:pt x="28" y="414"/>
                  </a:lnTo>
                  <a:lnTo>
                    <a:pt x="32" y="433"/>
                  </a:lnTo>
                  <a:lnTo>
                    <a:pt x="37" y="452"/>
                  </a:lnTo>
                  <a:lnTo>
                    <a:pt x="41" y="467"/>
                  </a:lnTo>
                  <a:lnTo>
                    <a:pt x="44" y="480"/>
                  </a:lnTo>
                  <a:lnTo>
                    <a:pt x="48" y="493"/>
                  </a:lnTo>
                  <a:lnTo>
                    <a:pt x="53" y="504"/>
                  </a:lnTo>
                  <a:lnTo>
                    <a:pt x="57" y="514"/>
                  </a:lnTo>
                  <a:lnTo>
                    <a:pt x="60" y="522"/>
                  </a:lnTo>
                  <a:lnTo>
                    <a:pt x="65" y="530"/>
                  </a:lnTo>
                  <a:lnTo>
                    <a:pt x="69" y="537"/>
                  </a:lnTo>
                  <a:lnTo>
                    <a:pt x="73" y="545"/>
                  </a:lnTo>
                  <a:lnTo>
                    <a:pt x="77" y="551"/>
                  </a:lnTo>
                  <a:lnTo>
                    <a:pt x="82" y="557"/>
                  </a:lnTo>
                  <a:lnTo>
                    <a:pt x="85" y="562"/>
                  </a:lnTo>
                  <a:lnTo>
                    <a:pt x="89" y="567"/>
                  </a:lnTo>
                  <a:lnTo>
                    <a:pt x="94" y="572"/>
                  </a:lnTo>
                  <a:lnTo>
                    <a:pt x="98" y="577"/>
                  </a:lnTo>
                  <a:lnTo>
                    <a:pt x="101" y="581"/>
                  </a:lnTo>
                  <a:lnTo>
                    <a:pt x="106" y="584"/>
                  </a:lnTo>
                  <a:lnTo>
                    <a:pt x="110" y="588"/>
                  </a:lnTo>
                  <a:lnTo>
                    <a:pt x="114" y="592"/>
                  </a:lnTo>
                  <a:lnTo>
                    <a:pt x="118" y="596"/>
                  </a:lnTo>
                  <a:lnTo>
                    <a:pt x="123" y="598"/>
                  </a:lnTo>
                  <a:lnTo>
                    <a:pt x="126" y="602"/>
                  </a:lnTo>
                  <a:lnTo>
                    <a:pt x="130" y="604"/>
                  </a:lnTo>
                  <a:lnTo>
                    <a:pt x="135" y="607"/>
                  </a:lnTo>
                  <a:lnTo>
                    <a:pt x="139" y="609"/>
                  </a:lnTo>
                  <a:lnTo>
                    <a:pt x="142" y="612"/>
                  </a:lnTo>
                  <a:lnTo>
                    <a:pt x="146" y="614"/>
                  </a:lnTo>
                  <a:lnTo>
                    <a:pt x="151" y="617"/>
                  </a:lnTo>
                  <a:lnTo>
                    <a:pt x="155" y="619"/>
                  </a:lnTo>
                  <a:lnTo>
                    <a:pt x="158" y="620"/>
                  </a:lnTo>
                  <a:lnTo>
                    <a:pt x="163" y="623"/>
                  </a:lnTo>
                  <a:lnTo>
                    <a:pt x="167" y="625"/>
                  </a:lnTo>
                  <a:lnTo>
                    <a:pt x="171" y="626"/>
                  </a:lnTo>
                  <a:lnTo>
                    <a:pt x="175" y="629"/>
                  </a:lnTo>
                  <a:lnTo>
                    <a:pt x="180" y="630"/>
                  </a:lnTo>
                  <a:lnTo>
                    <a:pt x="183" y="631"/>
                  </a:lnTo>
                  <a:lnTo>
                    <a:pt x="187" y="634"/>
                  </a:lnTo>
                  <a:lnTo>
                    <a:pt x="192" y="635"/>
                  </a:lnTo>
                  <a:lnTo>
                    <a:pt x="196" y="636"/>
                  </a:lnTo>
                  <a:lnTo>
                    <a:pt x="199" y="638"/>
                  </a:lnTo>
                  <a:lnTo>
                    <a:pt x="203" y="639"/>
                  </a:lnTo>
                  <a:lnTo>
                    <a:pt x="208" y="641"/>
                  </a:lnTo>
                  <a:lnTo>
                    <a:pt x="212" y="643"/>
                  </a:lnTo>
                  <a:lnTo>
                    <a:pt x="216" y="644"/>
                  </a:lnTo>
                  <a:lnTo>
                    <a:pt x="221" y="645"/>
                  </a:lnTo>
                  <a:lnTo>
                    <a:pt x="224" y="646"/>
                  </a:lnTo>
                  <a:lnTo>
                    <a:pt x="228" y="647"/>
                  </a:lnTo>
                  <a:lnTo>
                    <a:pt x="232" y="649"/>
                  </a:lnTo>
                  <a:lnTo>
                    <a:pt x="237" y="649"/>
                  </a:lnTo>
                  <a:lnTo>
                    <a:pt x="240" y="650"/>
                  </a:lnTo>
                  <a:lnTo>
                    <a:pt x="244" y="651"/>
                  </a:lnTo>
                  <a:lnTo>
                    <a:pt x="249" y="652"/>
                  </a:lnTo>
                  <a:lnTo>
                    <a:pt x="253" y="654"/>
                  </a:lnTo>
                  <a:lnTo>
                    <a:pt x="256" y="655"/>
                  </a:lnTo>
                  <a:lnTo>
                    <a:pt x="260" y="655"/>
                  </a:lnTo>
                  <a:lnTo>
                    <a:pt x="265" y="656"/>
                  </a:lnTo>
                  <a:lnTo>
                    <a:pt x="269" y="657"/>
                  </a:lnTo>
                  <a:lnTo>
                    <a:pt x="273" y="659"/>
                  </a:lnTo>
                  <a:lnTo>
                    <a:pt x="278" y="659"/>
                  </a:lnTo>
                  <a:lnTo>
                    <a:pt x="281" y="660"/>
                  </a:lnTo>
                  <a:lnTo>
                    <a:pt x="285" y="661"/>
                  </a:lnTo>
                  <a:lnTo>
                    <a:pt x="290" y="661"/>
                  </a:lnTo>
                  <a:lnTo>
                    <a:pt x="294" y="662"/>
                  </a:lnTo>
                  <a:lnTo>
                    <a:pt x="297" y="664"/>
                  </a:lnTo>
                  <a:lnTo>
                    <a:pt x="301" y="664"/>
                  </a:lnTo>
                  <a:lnTo>
                    <a:pt x="306" y="665"/>
                  </a:lnTo>
                  <a:lnTo>
                    <a:pt x="310" y="665"/>
                  </a:lnTo>
                  <a:lnTo>
                    <a:pt x="314" y="666"/>
                  </a:lnTo>
                  <a:lnTo>
                    <a:pt x="319" y="667"/>
                  </a:lnTo>
                  <a:lnTo>
                    <a:pt x="322" y="667"/>
                  </a:lnTo>
                  <a:lnTo>
                    <a:pt x="326" y="669"/>
                  </a:lnTo>
                  <a:lnTo>
                    <a:pt x="330" y="669"/>
                  </a:lnTo>
                  <a:lnTo>
                    <a:pt x="335" y="670"/>
                  </a:lnTo>
                  <a:lnTo>
                    <a:pt x="338" y="670"/>
                  </a:lnTo>
                  <a:lnTo>
                    <a:pt x="342" y="671"/>
                  </a:lnTo>
                  <a:lnTo>
                    <a:pt x="347" y="671"/>
                  </a:lnTo>
                  <a:lnTo>
                    <a:pt x="351" y="672"/>
                  </a:lnTo>
                  <a:lnTo>
                    <a:pt x="354" y="672"/>
                  </a:lnTo>
                  <a:lnTo>
                    <a:pt x="358" y="673"/>
                  </a:lnTo>
                  <a:lnTo>
                    <a:pt x="363" y="673"/>
                  </a:lnTo>
                  <a:lnTo>
                    <a:pt x="367" y="675"/>
                  </a:lnTo>
                  <a:lnTo>
                    <a:pt x="371" y="675"/>
                  </a:lnTo>
                  <a:lnTo>
                    <a:pt x="376" y="675"/>
                  </a:lnTo>
                  <a:lnTo>
                    <a:pt x="379" y="676"/>
                  </a:lnTo>
                  <a:lnTo>
                    <a:pt x="383" y="676"/>
                  </a:lnTo>
                  <a:lnTo>
                    <a:pt x="387" y="677"/>
                  </a:lnTo>
                  <a:lnTo>
                    <a:pt x="392" y="677"/>
                  </a:lnTo>
                  <a:lnTo>
                    <a:pt x="395" y="677"/>
                  </a:lnTo>
                  <a:lnTo>
                    <a:pt x="399" y="678"/>
                  </a:lnTo>
                  <a:lnTo>
                    <a:pt x="404" y="678"/>
                  </a:lnTo>
                  <a:lnTo>
                    <a:pt x="408" y="680"/>
                  </a:lnTo>
                  <a:lnTo>
                    <a:pt x="412" y="680"/>
                  </a:lnTo>
                  <a:lnTo>
                    <a:pt x="415" y="680"/>
                  </a:lnTo>
                  <a:lnTo>
                    <a:pt x="420" y="681"/>
                  </a:lnTo>
                  <a:lnTo>
                    <a:pt x="424" y="681"/>
                  </a:lnTo>
                  <a:lnTo>
                    <a:pt x="428" y="681"/>
                  </a:lnTo>
                  <a:lnTo>
                    <a:pt x="433" y="682"/>
                  </a:lnTo>
                  <a:lnTo>
                    <a:pt x="436" y="682"/>
                  </a:lnTo>
                  <a:lnTo>
                    <a:pt x="440" y="682"/>
                  </a:lnTo>
                  <a:lnTo>
                    <a:pt x="445" y="683"/>
                  </a:lnTo>
                  <a:lnTo>
                    <a:pt x="449" y="683"/>
                  </a:lnTo>
                  <a:lnTo>
                    <a:pt x="453" y="683"/>
                  </a:lnTo>
                  <a:lnTo>
                    <a:pt x="456" y="685"/>
                  </a:lnTo>
                  <a:lnTo>
                    <a:pt x="461" y="685"/>
                  </a:lnTo>
                  <a:lnTo>
                    <a:pt x="465" y="685"/>
                  </a:lnTo>
                  <a:lnTo>
                    <a:pt x="469" y="686"/>
                  </a:lnTo>
                  <a:lnTo>
                    <a:pt x="474" y="686"/>
                  </a:lnTo>
                  <a:lnTo>
                    <a:pt x="477" y="686"/>
                  </a:lnTo>
                  <a:lnTo>
                    <a:pt x="481" y="686"/>
                  </a:lnTo>
                  <a:lnTo>
                    <a:pt x="485" y="687"/>
                  </a:lnTo>
                  <a:lnTo>
                    <a:pt x="490" y="687"/>
                  </a:lnTo>
                  <a:lnTo>
                    <a:pt x="493" y="687"/>
                  </a:lnTo>
                  <a:lnTo>
                    <a:pt x="497" y="688"/>
                  </a:lnTo>
                  <a:lnTo>
                    <a:pt x="502" y="688"/>
                  </a:lnTo>
                  <a:lnTo>
                    <a:pt x="506" y="688"/>
                  </a:lnTo>
                  <a:lnTo>
                    <a:pt x="510" y="688"/>
                  </a:lnTo>
                  <a:lnTo>
                    <a:pt x="513" y="690"/>
                  </a:lnTo>
                  <a:lnTo>
                    <a:pt x="518" y="690"/>
                  </a:lnTo>
                  <a:lnTo>
                    <a:pt x="522" y="690"/>
                  </a:lnTo>
                  <a:lnTo>
                    <a:pt x="526" y="690"/>
                  </a:lnTo>
                  <a:lnTo>
                    <a:pt x="531" y="691"/>
                  </a:lnTo>
                  <a:lnTo>
                    <a:pt x="534" y="691"/>
                  </a:lnTo>
                  <a:lnTo>
                    <a:pt x="538" y="691"/>
                  </a:lnTo>
                  <a:lnTo>
                    <a:pt x="542" y="691"/>
                  </a:lnTo>
                  <a:lnTo>
                    <a:pt x="547" y="692"/>
                  </a:lnTo>
                  <a:lnTo>
                    <a:pt x="551" y="692"/>
                  </a:lnTo>
                  <a:lnTo>
                    <a:pt x="554" y="692"/>
                  </a:lnTo>
                  <a:lnTo>
                    <a:pt x="559" y="692"/>
                  </a:lnTo>
                  <a:lnTo>
                    <a:pt x="563" y="692"/>
                  </a:lnTo>
                  <a:lnTo>
                    <a:pt x="567" y="693"/>
                  </a:lnTo>
                  <a:lnTo>
                    <a:pt x="570" y="693"/>
                  </a:lnTo>
                  <a:lnTo>
                    <a:pt x="575" y="693"/>
                  </a:lnTo>
                  <a:lnTo>
                    <a:pt x="579" y="693"/>
                  </a:lnTo>
                  <a:lnTo>
                    <a:pt x="583" y="695"/>
                  </a:lnTo>
                  <a:lnTo>
                    <a:pt x="588" y="695"/>
                  </a:lnTo>
                  <a:lnTo>
                    <a:pt x="591" y="695"/>
                  </a:lnTo>
                  <a:lnTo>
                    <a:pt x="595" y="695"/>
                  </a:lnTo>
                  <a:lnTo>
                    <a:pt x="599" y="695"/>
                  </a:lnTo>
                  <a:lnTo>
                    <a:pt x="604" y="696"/>
                  </a:lnTo>
                  <a:lnTo>
                    <a:pt x="608" y="696"/>
                  </a:lnTo>
                  <a:lnTo>
                    <a:pt x="611" y="696"/>
                  </a:lnTo>
                  <a:lnTo>
                    <a:pt x="616" y="696"/>
                  </a:lnTo>
                  <a:lnTo>
                    <a:pt x="620" y="696"/>
                  </a:lnTo>
                  <a:lnTo>
                    <a:pt x="624" y="696"/>
                  </a:lnTo>
                  <a:lnTo>
                    <a:pt x="629" y="697"/>
                  </a:lnTo>
                  <a:lnTo>
                    <a:pt x="632" y="697"/>
                  </a:lnTo>
                  <a:lnTo>
                    <a:pt x="636" y="697"/>
                  </a:lnTo>
                  <a:lnTo>
                    <a:pt x="640" y="697"/>
                  </a:lnTo>
                  <a:lnTo>
                    <a:pt x="645" y="697"/>
                  </a:lnTo>
                  <a:lnTo>
                    <a:pt x="649" y="698"/>
                  </a:lnTo>
                  <a:lnTo>
                    <a:pt x="652" y="698"/>
                  </a:lnTo>
                  <a:lnTo>
                    <a:pt x="657" y="698"/>
                  </a:lnTo>
                  <a:lnTo>
                    <a:pt x="661" y="698"/>
                  </a:lnTo>
                  <a:lnTo>
                    <a:pt x="665" y="698"/>
                  </a:lnTo>
                  <a:lnTo>
                    <a:pt x="668" y="698"/>
                  </a:lnTo>
                  <a:lnTo>
                    <a:pt x="673" y="699"/>
                  </a:lnTo>
                  <a:lnTo>
                    <a:pt x="677" y="699"/>
                  </a:lnTo>
                  <a:lnTo>
                    <a:pt x="681" y="699"/>
                  </a:lnTo>
                  <a:lnTo>
                    <a:pt x="686" y="699"/>
                  </a:lnTo>
                  <a:lnTo>
                    <a:pt x="689" y="699"/>
                  </a:lnTo>
                  <a:lnTo>
                    <a:pt x="693" y="699"/>
                  </a:lnTo>
                  <a:lnTo>
                    <a:pt x="697" y="701"/>
                  </a:lnTo>
                  <a:lnTo>
                    <a:pt x="702" y="701"/>
                  </a:lnTo>
                  <a:lnTo>
                    <a:pt x="706" y="701"/>
                  </a:lnTo>
                  <a:lnTo>
                    <a:pt x="709" y="701"/>
                  </a:lnTo>
                  <a:lnTo>
                    <a:pt x="714" y="701"/>
                  </a:lnTo>
                  <a:lnTo>
                    <a:pt x="718" y="701"/>
                  </a:lnTo>
                  <a:lnTo>
                    <a:pt x="722" y="701"/>
                  </a:lnTo>
                  <a:lnTo>
                    <a:pt x="725" y="702"/>
                  </a:lnTo>
                  <a:lnTo>
                    <a:pt x="730" y="702"/>
                  </a:lnTo>
                  <a:lnTo>
                    <a:pt x="734" y="702"/>
                  </a:lnTo>
                  <a:lnTo>
                    <a:pt x="738" y="702"/>
                  </a:lnTo>
                  <a:lnTo>
                    <a:pt x="743" y="702"/>
                  </a:lnTo>
                  <a:lnTo>
                    <a:pt x="747" y="702"/>
                  </a:lnTo>
                  <a:lnTo>
                    <a:pt x="750" y="702"/>
                  </a:lnTo>
                  <a:lnTo>
                    <a:pt x="754" y="703"/>
                  </a:lnTo>
                  <a:lnTo>
                    <a:pt x="759" y="703"/>
                  </a:lnTo>
                  <a:lnTo>
                    <a:pt x="763" y="703"/>
                  </a:lnTo>
                  <a:lnTo>
                    <a:pt x="766" y="703"/>
                  </a:lnTo>
                  <a:lnTo>
                    <a:pt x="771" y="703"/>
                  </a:lnTo>
                  <a:lnTo>
                    <a:pt x="775" y="703"/>
                  </a:lnTo>
                  <a:lnTo>
                    <a:pt x="779" y="703"/>
                  </a:lnTo>
                  <a:lnTo>
                    <a:pt x="783" y="704"/>
                  </a:lnTo>
                  <a:lnTo>
                    <a:pt x="787" y="704"/>
                  </a:lnTo>
                  <a:lnTo>
                    <a:pt x="791" y="704"/>
                  </a:lnTo>
                  <a:lnTo>
                    <a:pt x="795" y="704"/>
                  </a:lnTo>
                  <a:lnTo>
                    <a:pt x="800" y="704"/>
                  </a:lnTo>
                  <a:lnTo>
                    <a:pt x="804" y="704"/>
                  </a:lnTo>
                  <a:lnTo>
                    <a:pt x="807" y="704"/>
                  </a:lnTo>
                  <a:lnTo>
                    <a:pt x="812" y="704"/>
                  </a:lnTo>
                  <a:lnTo>
                    <a:pt x="816" y="706"/>
                  </a:lnTo>
                  <a:lnTo>
                    <a:pt x="820" y="706"/>
                  </a:lnTo>
                  <a:lnTo>
                    <a:pt x="823" y="706"/>
                  </a:lnTo>
                  <a:lnTo>
                    <a:pt x="828" y="706"/>
                  </a:lnTo>
                  <a:lnTo>
                    <a:pt x="832" y="706"/>
                  </a:lnTo>
                  <a:lnTo>
                    <a:pt x="836" y="706"/>
                  </a:lnTo>
                  <a:lnTo>
                    <a:pt x="841" y="706"/>
                  </a:lnTo>
                  <a:lnTo>
                    <a:pt x="845" y="706"/>
                  </a:lnTo>
                  <a:lnTo>
                    <a:pt x="848" y="706"/>
                  </a:lnTo>
                  <a:lnTo>
                    <a:pt x="852" y="707"/>
                  </a:lnTo>
                  <a:lnTo>
                    <a:pt x="857" y="707"/>
                  </a:lnTo>
                  <a:lnTo>
                    <a:pt x="861" y="707"/>
                  </a:lnTo>
                  <a:lnTo>
                    <a:pt x="864" y="707"/>
                  </a:lnTo>
                  <a:lnTo>
                    <a:pt x="869" y="707"/>
                  </a:lnTo>
                  <a:lnTo>
                    <a:pt x="873" y="707"/>
                  </a:lnTo>
                  <a:lnTo>
                    <a:pt x="877" y="707"/>
                  </a:lnTo>
                  <a:lnTo>
                    <a:pt x="881" y="707"/>
                  </a:lnTo>
                  <a:lnTo>
                    <a:pt x="885" y="707"/>
                  </a:lnTo>
                  <a:lnTo>
                    <a:pt x="889" y="708"/>
                  </a:lnTo>
                  <a:lnTo>
                    <a:pt x="893" y="708"/>
                  </a:lnTo>
                  <a:lnTo>
                    <a:pt x="898" y="708"/>
                  </a:lnTo>
                  <a:lnTo>
                    <a:pt x="902" y="708"/>
                  </a:lnTo>
                  <a:lnTo>
                    <a:pt x="905" y="708"/>
                  </a:lnTo>
                  <a:lnTo>
                    <a:pt x="909" y="708"/>
                  </a:lnTo>
                  <a:lnTo>
                    <a:pt x="914" y="708"/>
                  </a:lnTo>
                  <a:lnTo>
                    <a:pt x="918" y="708"/>
                  </a:lnTo>
                  <a:lnTo>
                    <a:pt x="921" y="708"/>
                  </a:lnTo>
                  <a:lnTo>
                    <a:pt x="926" y="708"/>
                  </a:lnTo>
                  <a:lnTo>
                    <a:pt x="930" y="709"/>
                  </a:lnTo>
                  <a:lnTo>
                    <a:pt x="934" y="709"/>
                  </a:lnTo>
                  <a:lnTo>
                    <a:pt x="938" y="709"/>
                  </a:lnTo>
                  <a:lnTo>
                    <a:pt x="943" y="709"/>
                  </a:lnTo>
                  <a:lnTo>
                    <a:pt x="946" y="709"/>
                  </a:lnTo>
                  <a:lnTo>
                    <a:pt x="950" y="709"/>
                  </a:lnTo>
                  <a:lnTo>
                    <a:pt x="955" y="709"/>
                  </a:lnTo>
                  <a:lnTo>
                    <a:pt x="959" y="709"/>
                  </a:lnTo>
                  <a:lnTo>
                    <a:pt x="962" y="709"/>
                  </a:lnTo>
                  <a:lnTo>
                    <a:pt x="967" y="709"/>
                  </a:lnTo>
                  <a:lnTo>
                    <a:pt x="971" y="709"/>
                  </a:lnTo>
                  <a:lnTo>
                    <a:pt x="975" y="711"/>
                  </a:lnTo>
                  <a:lnTo>
                    <a:pt x="979" y="711"/>
                  </a:lnTo>
                  <a:lnTo>
                    <a:pt x="983" y="711"/>
                  </a:lnTo>
                  <a:lnTo>
                    <a:pt x="987" y="711"/>
                  </a:lnTo>
                  <a:lnTo>
                    <a:pt x="991" y="711"/>
                  </a:lnTo>
                  <a:lnTo>
                    <a:pt x="996" y="711"/>
                  </a:lnTo>
                  <a:lnTo>
                    <a:pt x="1000" y="711"/>
                  </a:lnTo>
                  <a:lnTo>
                    <a:pt x="1003" y="711"/>
                  </a:lnTo>
                  <a:lnTo>
                    <a:pt x="1007" y="711"/>
                  </a:lnTo>
                  <a:lnTo>
                    <a:pt x="1012" y="711"/>
                  </a:lnTo>
                  <a:lnTo>
                    <a:pt x="1016" y="711"/>
                  </a:lnTo>
                  <a:lnTo>
                    <a:pt x="1019" y="712"/>
                  </a:lnTo>
                  <a:lnTo>
                    <a:pt x="1024" y="712"/>
                  </a:lnTo>
                  <a:lnTo>
                    <a:pt x="1028" y="712"/>
                  </a:lnTo>
                  <a:lnTo>
                    <a:pt x="1032" y="712"/>
                  </a:lnTo>
                  <a:lnTo>
                    <a:pt x="1036" y="712"/>
                  </a:lnTo>
                  <a:lnTo>
                    <a:pt x="1041" y="712"/>
                  </a:lnTo>
                  <a:lnTo>
                    <a:pt x="1044" y="712"/>
                  </a:lnTo>
                  <a:lnTo>
                    <a:pt x="1048" y="712"/>
                  </a:lnTo>
                  <a:lnTo>
                    <a:pt x="1053" y="712"/>
                  </a:lnTo>
                  <a:lnTo>
                    <a:pt x="1057" y="712"/>
                  </a:lnTo>
                  <a:lnTo>
                    <a:pt x="1060" y="712"/>
                  </a:lnTo>
                  <a:lnTo>
                    <a:pt x="1064" y="712"/>
                  </a:lnTo>
                  <a:lnTo>
                    <a:pt x="1069" y="712"/>
                  </a:lnTo>
                  <a:lnTo>
                    <a:pt x="1073" y="713"/>
                  </a:lnTo>
                  <a:lnTo>
                    <a:pt x="1077" y="713"/>
                  </a:lnTo>
                  <a:lnTo>
                    <a:pt x="1082" y="713"/>
                  </a:lnTo>
                  <a:lnTo>
                    <a:pt x="1085" y="713"/>
                  </a:lnTo>
                  <a:lnTo>
                    <a:pt x="1089" y="713"/>
                  </a:lnTo>
                  <a:lnTo>
                    <a:pt x="1093" y="713"/>
                  </a:lnTo>
                  <a:lnTo>
                    <a:pt x="1098" y="713"/>
                  </a:lnTo>
                  <a:lnTo>
                    <a:pt x="1101" y="713"/>
                  </a:lnTo>
                  <a:lnTo>
                    <a:pt x="1105" y="713"/>
                  </a:lnTo>
                  <a:lnTo>
                    <a:pt x="1110" y="713"/>
                  </a:lnTo>
                  <a:lnTo>
                    <a:pt x="1114" y="713"/>
                  </a:lnTo>
                  <a:lnTo>
                    <a:pt x="1117" y="713"/>
                  </a:lnTo>
                  <a:lnTo>
                    <a:pt x="1121" y="713"/>
                  </a:lnTo>
                  <a:lnTo>
                    <a:pt x="1126" y="713"/>
                  </a:lnTo>
                  <a:lnTo>
                    <a:pt x="1130" y="714"/>
                  </a:lnTo>
                  <a:lnTo>
                    <a:pt x="1134" y="714"/>
                  </a:lnTo>
                  <a:lnTo>
                    <a:pt x="1139" y="714"/>
                  </a:lnTo>
                  <a:lnTo>
                    <a:pt x="1142" y="714"/>
                  </a:lnTo>
                  <a:lnTo>
                    <a:pt x="1146" y="714"/>
                  </a:lnTo>
                  <a:lnTo>
                    <a:pt x="1151" y="714"/>
                  </a:lnTo>
                  <a:lnTo>
                    <a:pt x="1155" y="714"/>
                  </a:lnTo>
                  <a:lnTo>
                    <a:pt x="1158" y="714"/>
                  </a:lnTo>
                  <a:lnTo>
                    <a:pt x="1162" y="714"/>
                  </a:lnTo>
                  <a:lnTo>
                    <a:pt x="1167" y="714"/>
                  </a:lnTo>
                  <a:lnTo>
                    <a:pt x="1171" y="714"/>
                  </a:lnTo>
                  <a:lnTo>
                    <a:pt x="1175" y="714"/>
                  </a:lnTo>
                  <a:lnTo>
                    <a:pt x="1180" y="714"/>
                  </a:lnTo>
                  <a:lnTo>
                    <a:pt x="1183" y="714"/>
                  </a:lnTo>
                  <a:lnTo>
                    <a:pt x="1187" y="716"/>
                  </a:lnTo>
                  <a:lnTo>
                    <a:pt x="1191" y="716"/>
                  </a:lnTo>
                  <a:lnTo>
                    <a:pt x="1196" y="716"/>
                  </a:lnTo>
                  <a:lnTo>
                    <a:pt x="1199" y="716"/>
                  </a:lnTo>
                  <a:lnTo>
                    <a:pt x="1203" y="716"/>
                  </a:lnTo>
                  <a:lnTo>
                    <a:pt x="1208" y="716"/>
                  </a:lnTo>
                  <a:lnTo>
                    <a:pt x="1212" y="716"/>
                  </a:lnTo>
                  <a:lnTo>
                    <a:pt x="1215" y="716"/>
                  </a:lnTo>
                  <a:lnTo>
                    <a:pt x="1219" y="716"/>
                  </a:lnTo>
                  <a:lnTo>
                    <a:pt x="1224" y="716"/>
                  </a:lnTo>
                  <a:lnTo>
                    <a:pt x="1228" y="716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216400" y="4246560"/>
              <a:ext cx="49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310720" y="4278240"/>
              <a:ext cx="4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351040" y="4246560"/>
              <a:ext cx="45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= 0.99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699000" y="518328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638160" y="48909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579840" y="45975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579840" y="430704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579840" y="401472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579840" y="37209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807000" y="53370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169880" y="53370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563720" y="53370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959000" y="53370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352840" y="53370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716440" y="53370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6110280" y="53370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782960" y="3549600"/>
              <a:ext cx="747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MEK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3363840" y="3529080"/>
              <a:ext cx="35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U)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572360" y="5457960"/>
              <a:ext cx="913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fold dilution)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45" name=""/>
          <p:cNvSpPr/>
          <p:nvPr/>
        </p:nvSpPr>
        <p:spPr>
          <a:xfrm>
            <a:off x="5299560" y="541440"/>
            <a:ext cx="115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 Rounded MT Bold"/>
              </a:rPr>
              <a:t>Takano et al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高野 重紹</cp:lastModifiedBy>
  <cp:lastPrinted>2009-01-13T05:13:19Z</cp:lastPrinted>
  <dcterms:modified xsi:type="dcterms:W3CDTF">2009-12-09T10:55:48Z</dcterms:modified>
  <cp:revision>244</cp:revision>
  <dc:subject/>
  <dc:title>PowerPoint プレゼンテーション</dc:title>
</cp:coreProperties>
</file>